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7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8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9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0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1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2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3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4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5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6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7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8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9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20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21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349" r:id="rId2"/>
    <p:sldId id="381" r:id="rId3"/>
    <p:sldId id="383" r:id="rId4"/>
    <p:sldId id="388" r:id="rId5"/>
    <p:sldId id="256" r:id="rId6"/>
    <p:sldId id="273" r:id="rId7"/>
    <p:sldId id="382" r:id="rId8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1920" userDrawn="1">
          <p15:clr>
            <a:srgbClr val="A4A3A4"/>
          </p15:clr>
        </p15:guide>
        <p15:guide id="3" orient="horz" pos="1920" userDrawn="1">
          <p15:clr>
            <a:srgbClr val="A4A3A4"/>
          </p15:clr>
        </p15:guide>
        <p15:guide id="4" orient="horz" pos="38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449"/>
    <p:restoredTop sz="96327"/>
  </p:normalViewPr>
  <p:slideViewPr>
    <p:cSldViewPr snapToGrid="0" snapToObjects="1" showGuides="1">
      <p:cViewPr varScale="1">
        <p:scale>
          <a:sx n="107" d="100"/>
          <a:sy n="107" d="100"/>
        </p:scale>
        <p:origin x="184" y="2560"/>
      </p:cViewPr>
      <p:guideLst>
        <p:guide pos="1920"/>
        <p:guide orient="horz" pos="1920"/>
        <p:guide orient="horz" pos="388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kang1/Documents/Project%202016/Glis3_Thyroid/Results/GTr16-020%20Glis3%20exp%20from%20different%20ages/GTr16-020%20RT_PCR_total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06_5W%20ND-LID%20QRT/GTr21-06%205W%20ND%20LID%20QRT_total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kang1/Documents/Project%202016/Glis3_Thyroid/Results/GTr16-020%20Glis3%20exp%20from%20different%20ages/GTr16-020%20RT_PCR_total.xlsx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06_5W%20ND-LID%20QRT/GTr21-06%205W%20ND%20LID%20QRT_total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06_5W%20ND-LID%20QRT/GTr21-06%205W%20ND%20LID%20QRT_total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3-23%20PI3K%20inh/GTr23-23%20PI3K%20in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3-01%20Islet%20QRT/GTr23-01CKO%20islet_18S-Glis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3-01%20Islet%20QRT/GTr23-01CKO%20islet_18S-Glis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3-01%20Islet%20QRT/GTr23-01CKO%20islet_18S-Glis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3-01%20Islet%20QRT/GTr23-01CKO%20islet_18S-Glis3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kang1/Documents/Project%202021/Glis3_Thyroid/Results_2/GTr21-34%20male%20QRT/GTR21-34%20male%20QRT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>
        <c:manualLayout>
          <c:xMode val="edge"/>
          <c:yMode val="edge"/>
          <c:x val="0.38208362988250621"/>
          <c:y val="1.5700372605693177E-2"/>
        </c:manualLayout>
      </c:layout>
      <c:overlay val="0"/>
      <c:txPr>
        <a:bodyPr/>
        <a:lstStyle/>
        <a:p>
          <a:pPr>
            <a:defRPr sz="1200" b="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082926201743673"/>
          <c:y val="0.34462949500691437"/>
          <c:w val="0.79380586137062958"/>
          <c:h val="0.40694136120830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Glis3!$D$22</c:f>
              <c:strCache>
                <c:ptCount val="1"/>
                <c:pt idx="0">
                  <c:v>mGlis3</c:v>
                </c:pt>
              </c:strCache>
            </c:strRef>
          </c:tx>
          <c:spPr>
            <a:solidFill>
              <a:srgbClr val="000000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Glis3!$D$31:$D$36</c:f>
                <c:numCache>
                  <c:formatCode>General</c:formatCode>
                  <c:ptCount val="6"/>
                  <c:pt idx="0">
                    <c:v>6.8179022811274803E-2</c:v>
                  </c:pt>
                  <c:pt idx="1">
                    <c:v>2.7618215755371101E-2</c:v>
                  </c:pt>
                  <c:pt idx="2">
                    <c:v>3.9301897979579899E-2</c:v>
                  </c:pt>
                  <c:pt idx="3">
                    <c:v>1.21448175246866E-2</c:v>
                  </c:pt>
                  <c:pt idx="4">
                    <c:v>6.1965762801228903E-2</c:v>
                  </c:pt>
                  <c:pt idx="5">
                    <c:v>3.1618087640654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Glis3!$C$23:$C$28</c:f>
              <c:strCache>
                <c:ptCount val="6"/>
                <c:pt idx="0">
                  <c:v>1W</c:v>
                </c:pt>
                <c:pt idx="1">
                  <c:v>2W</c:v>
                </c:pt>
                <c:pt idx="2">
                  <c:v>4W</c:v>
                </c:pt>
                <c:pt idx="3">
                  <c:v>6W</c:v>
                </c:pt>
                <c:pt idx="4">
                  <c:v>13W</c:v>
                </c:pt>
                <c:pt idx="5">
                  <c:v>10 M</c:v>
                </c:pt>
              </c:strCache>
            </c:strRef>
          </c:cat>
          <c:val>
            <c:numRef>
              <c:f>mGlis3!$D$23:$D$28</c:f>
              <c:numCache>
                <c:formatCode>General</c:formatCode>
                <c:ptCount val="6"/>
                <c:pt idx="0">
                  <c:v>0.18452152520329601</c:v>
                </c:pt>
                <c:pt idx="1">
                  <c:v>0.25605097387057801</c:v>
                </c:pt>
                <c:pt idx="2">
                  <c:v>0.155943681962152</c:v>
                </c:pt>
                <c:pt idx="3">
                  <c:v>0.122199417683571</c:v>
                </c:pt>
                <c:pt idx="4">
                  <c:v>0.18097030498562999</c:v>
                </c:pt>
                <c:pt idx="5">
                  <c:v>0.117429790120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87-ED4A-936E-7C1BBC51C2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8952272"/>
        <c:axId val="418949184"/>
      </c:barChart>
      <c:catAx>
        <c:axId val="4189522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n-US"/>
          </a:p>
        </c:txPr>
        <c:crossAx val="418949184"/>
        <c:crosses val="autoZero"/>
        <c:auto val="1"/>
        <c:lblAlgn val="ctr"/>
        <c:lblOffset val="100"/>
        <c:noMultiLvlLbl val="0"/>
      </c:catAx>
      <c:valAx>
        <c:axId val="4189491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189522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Ccnb1</a:t>
            </a:r>
          </a:p>
        </c:rich>
      </c:tx>
      <c:layout>
        <c:manualLayout>
          <c:xMode val="edge"/>
          <c:yMode val="edge"/>
          <c:x val="0.4367228915662650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6371612968668776E-2"/>
          <c:y val="0.26118066491688541"/>
          <c:w val="0.92362838703133121"/>
          <c:h val="0.6068097112860892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cnb1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cnb1!$D$35:$E$35</c:f>
                <c:numCache>
                  <c:formatCode>General</c:formatCode>
                  <c:ptCount val="2"/>
                  <c:pt idx="0">
                    <c:v>0.42542648622454876</c:v>
                  </c:pt>
                  <c:pt idx="1">
                    <c:v>3.15077327678118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cnb1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Ccnb1!$D$31:$E$31</c:f>
              <c:numCache>
                <c:formatCode>General</c:formatCode>
                <c:ptCount val="2"/>
                <c:pt idx="0">
                  <c:v>1</c:v>
                </c:pt>
                <c:pt idx="1">
                  <c:v>10.3273815742148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F8-BD4D-B6EC-D99ECB2C9F4B}"/>
            </c:ext>
          </c:extLst>
        </c:ser>
        <c:ser>
          <c:idx val="1"/>
          <c:order val="1"/>
          <c:tx>
            <c:strRef>
              <c:f>Ccnb1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cnb1!$D$36:$E$36</c:f>
                <c:numCache>
                  <c:formatCode>General</c:formatCode>
                  <c:ptCount val="2"/>
                  <c:pt idx="0">
                    <c:v>1.9470803040844293</c:v>
                  </c:pt>
                  <c:pt idx="1">
                    <c:v>3.29176374913661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cnb1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Ccnb1!$D$32:$E$32</c:f>
              <c:numCache>
                <c:formatCode>General</c:formatCode>
                <c:ptCount val="2"/>
                <c:pt idx="0">
                  <c:v>2.5860047249892721</c:v>
                </c:pt>
                <c:pt idx="1">
                  <c:v>8.82931596368244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F8-BD4D-B6EC-D99ECB2C9F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Cdca2</a:t>
            </a:r>
          </a:p>
        </c:rich>
      </c:tx>
      <c:layout>
        <c:manualLayout>
          <c:xMode val="edge"/>
          <c:yMode val="edge"/>
          <c:x val="0.38116724992709244"/>
          <c:y val="2.08333333333333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6371612968668776E-2"/>
          <c:y val="0.2811605424321959"/>
          <c:w val="0.92362838703133121"/>
          <c:h val="0.586829833770778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dca2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dca2!$D$35:$E$35</c:f>
                <c:numCache>
                  <c:formatCode>General</c:formatCode>
                  <c:ptCount val="2"/>
                  <c:pt idx="0">
                    <c:v>0.50197993537098051</c:v>
                  </c:pt>
                  <c:pt idx="1">
                    <c:v>1.77972113874424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dca2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Cdca2!$D$31:$E$31</c:f>
              <c:numCache>
                <c:formatCode>General</c:formatCode>
                <c:ptCount val="2"/>
                <c:pt idx="0">
                  <c:v>1</c:v>
                </c:pt>
                <c:pt idx="1">
                  <c:v>7.5491775221220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F3-964A-B188-F70E8C078CEB}"/>
            </c:ext>
          </c:extLst>
        </c:ser>
        <c:ser>
          <c:idx val="1"/>
          <c:order val="1"/>
          <c:tx>
            <c:strRef>
              <c:f>Cdca2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dca2!$D$36:$E$36</c:f>
                <c:numCache>
                  <c:formatCode>General</c:formatCode>
                  <c:ptCount val="2"/>
                  <c:pt idx="0">
                    <c:v>0.96755133130294768</c:v>
                  </c:pt>
                  <c:pt idx="1">
                    <c:v>2.68436148265566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dca2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Cdca2!$D$32:$E$32</c:f>
              <c:numCache>
                <c:formatCode>General</c:formatCode>
                <c:ptCount val="2"/>
                <c:pt idx="0">
                  <c:v>2.14844545095941</c:v>
                </c:pt>
                <c:pt idx="1">
                  <c:v>8.60872080813835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F3-964A-B188-F70E8C078C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Col18a1</a:t>
            </a:r>
          </a:p>
        </c:rich>
      </c:tx>
      <c:layout>
        <c:manualLayout>
          <c:xMode val="edge"/>
          <c:yMode val="edge"/>
          <c:x val="0.31866743219597549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751144238691888"/>
          <c:y val="0.26256944444444447"/>
          <c:w val="0.92362838703133121"/>
          <c:h val="0.565439085739282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ol18a1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ol18a1!$D$35:$E$35</c:f>
                <c:numCache>
                  <c:formatCode>General</c:formatCode>
                  <c:ptCount val="2"/>
                  <c:pt idx="0">
                    <c:v>0.40432604831662966</c:v>
                  </c:pt>
                  <c:pt idx="1">
                    <c:v>0.803296404938619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l18a1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Col18a1!$D$31:$E$31</c:f>
              <c:numCache>
                <c:formatCode>General</c:formatCode>
                <c:ptCount val="2"/>
                <c:pt idx="0">
                  <c:v>1</c:v>
                </c:pt>
                <c:pt idx="1">
                  <c:v>2.25418106206379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BC-2645-988D-117DB057FBB4}"/>
            </c:ext>
          </c:extLst>
        </c:ser>
        <c:ser>
          <c:idx val="1"/>
          <c:order val="1"/>
          <c:tx>
            <c:strRef>
              <c:f>Col18a1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ol18a1!$D$36:$E$36</c:f>
                <c:numCache>
                  <c:formatCode>General</c:formatCode>
                  <c:ptCount val="2"/>
                  <c:pt idx="0">
                    <c:v>0.12021842485875923</c:v>
                  </c:pt>
                  <c:pt idx="1">
                    <c:v>0.170142456254965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l18a1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Col18a1!$D$32:$E$32</c:f>
              <c:numCache>
                <c:formatCode>General</c:formatCode>
                <c:ptCount val="2"/>
                <c:pt idx="0">
                  <c:v>0.33488386101433137</c:v>
                </c:pt>
                <c:pt idx="1">
                  <c:v>0.544496331134737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BC-2645-988D-117DB057FB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Col4a1</a:t>
            </a:r>
          </a:p>
        </c:rich>
      </c:tx>
      <c:layout>
        <c:manualLayout>
          <c:xMode val="edge"/>
          <c:yMode val="edge"/>
          <c:x val="0.3533896544181977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993657042869641"/>
          <c:y val="0.26219488188976375"/>
          <c:w val="0.92362838703133121"/>
          <c:h val="0.566906714785651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ol4a1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ol4a1!$D$35:$E$35</c:f>
                <c:numCache>
                  <c:formatCode>General</c:formatCode>
                  <c:ptCount val="2"/>
                  <c:pt idx="0">
                    <c:v>0.54103527836317944</c:v>
                  </c:pt>
                  <c:pt idx="1">
                    <c:v>0.927534381799259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l4a1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Col4a1!$D$31:$E$31</c:f>
              <c:numCache>
                <c:formatCode>General</c:formatCode>
                <c:ptCount val="2"/>
                <c:pt idx="0">
                  <c:v>1</c:v>
                </c:pt>
                <c:pt idx="1">
                  <c:v>3.2955053430788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A2-3D48-8EEF-06D556214AEF}"/>
            </c:ext>
          </c:extLst>
        </c:ser>
        <c:ser>
          <c:idx val="1"/>
          <c:order val="1"/>
          <c:tx>
            <c:strRef>
              <c:f>Col4a1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ol4a1!$D$36:$E$36</c:f>
                <c:numCache>
                  <c:formatCode>General</c:formatCode>
                  <c:ptCount val="2"/>
                  <c:pt idx="0">
                    <c:v>0.3315473666194011</c:v>
                  </c:pt>
                  <c:pt idx="1">
                    <c:v>0.49369280341456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l4a1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Col4a1!$D$32:$E$32</c:f>
              <c:numCache>
                <c:formatCode>General</c:formatCode>
                <c:ptCount val="2"/>
                <c:pt idx="0">
                  <c:v>0.68825632336553155</c:v>
                </c:pt>
                <c:pt idx="1">
                  <c:v>1.08183342846093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A2-3D48-8EEF-06D556214A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Foxe1</a:t>
            </a:r>
          </a:p>
        </c:rich>
      </c:tx>
      <c:layout>
        <c:manualLayout>
          <c:xMode val="edge"/>
          <c:yMode val="edge"/>
          <c:x val="0.4367228915662650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106249980783007"/>
          <c:y val="0.25795330271216099"/>
          <c:w val="0.92362838703133121"/>
          <c:h val="0.57703466754155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oxe1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oxe1!$D$35:$E$35</c:f>
                <c:numCache>
                  <c:formatCode>General</c:formatCode>
                  <c:ptCount val="2"/>
                  <c:pt idx="0">
                    <c:v>0.21445265585008108</c:v>
                  </c:pt>
                  <c:pt idx="1">
                    <c:v>8.913555668168593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xe1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Foxe1!$D$31:$E$31</c:f>
              <c:numCache>
                <c:formatCode>General</c:formatCode>
                <c:ptCount val="2"/>
                <c:pt idx="0">
                  <c:v>1</c:v>
                </c:pt>
                <c:pt idx="1">
                  <c:v>0.869893700083613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C6-D847-A2B6-D6071F91F40F}"/>
            </c:ext>
          </c:extLst>
        </c:ser>
        <c:ser>
          <c:idx val="1"/>
          <c:order val="1"/>
          <c:tx>
            <c:strRef>
              <c:f>Foxe1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oxe1!$D$36:$E$36</c:f>
                <c:numCache>
                  <c:formatCode>General</c:formatCode>
                  <c:ptCount val="2"/>
                  <c:pt idx="0">
                    <c:v>0.25986169733840458</c:v>
                  </c:pt>
                  <c:pt idx="1">
                    <c:v>0.240362429453543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xe1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Foxe1!$D$32:$E$32</c:f>
              <c:numCache>
                <c:formatCode>General</c:formatCode>
                <c:ptCount val="2"/>
                <c:pt idx="0">
                  <c:v>1.0709412549021851</c:v>
                </c:pt>
                <c:pt idx="1">
                  <c:v>0.84146121112718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4C6-D847-A2B6-D6071F91F4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Pax8</a:t>
            </a:r>
          </a:p>
        </c:rich>
      </c:tx>
      <c:layout>
        <c:manualLayout>
          <c:xMode val="edge"/>
          <c:yMode val="edge"/>
          <c:x val="0.4367228915662650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6371612968668776E-2"/>
          <c:y val="0.26913659230096232"/>
          <c:w val="0.92362838703133121"/>
          <c:h val="0.565851377952755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ax8'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ax8'!$D$35:$E$35</c:f>
                <c:numCache>
                  <c:formatCode>General</c:formatCode>
                  <c:ptCount val="2"/>
                  <c:pt idx="0">
                    <c:v>0.3646688768438841</c:v>
                  </c:pt>
                  <c:pt idx="1">
                    <c:v>0.117240855764608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x8'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Pax8'!$D$31:$E$31</c:f>
              <c:numCache>
                <c:formatCode>General</c:formatCode>
                <c:ptCount val="2"/>
                <c:pt idx="0">
                  <c:v>1</c:v>
                </c:pt>
                <c:pt idx="1">
                  <c:v>0.810926911653901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FC-6B4B-BFA1-01BCD0764F2A}"/>
            </c:ext>
          </c:extLst>
        </c:ser>
        <c:ser>
          <c:idx val="1"/>
          <c:order val="1"/>
          <c:tx>
            <c:strRef>
              <c:f>'Pax8'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ax8'!$D$36:$E$36</c:f>
                <c:numCache>
                  <c:formatCode>General</c:formatCode>
                  <c:ptCount val="2"/>
                  <c:pt idx="0">
                    <c:v>0.54767770943802763</c:v>
                  </c:pt>
                  <c:pt idx="1">
                    <c:v>0.537076727841680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x8'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Pax8'!$D$32:$E$32</c:f>
              <c:numCache>
                <c:formatCode>General</c:formatCode>
                <c:ptCount val="2"/>
                <c:pt idx="0">
                  <c:v>2.0085665316079009</c:v>
                </c:pt>
                <c:pt idx="1">
                  <c:v>1.90396412355035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BFC-6B4B-BFA1-01BCD0764F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Nkx2.1</a:t>
            </a:r>
          </a:p>
        </c:rich>
      </c:tx>
      <c:layout>
        <c:manualLayout>
          <c:xMode val="edge"/>
          <c:yMode val="edge"/>
          <c:x val="0.3940390206194229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6371612968668776E-2"/>
          <c:y val="0.26184619336091763"/>
          <c:w val="0.92362838703133121"/>
          <c:h val="0.571824548852267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kx2.1'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kx2.1'!$D$35:$E$35</c:f>
                <c:numCache>
                  <c:formatCode>General</c:formatCode>
                  <c:ptCount val="2"/>
                  <c:pt idx="0">
                    <c:v>0.33824246689939724</c:v>
                  </c:pt>
                  <c:pt idx="1">
                    <c:v>9.396906944269549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kx2.1'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Nkx2.1'!$D$31:$E$31</c:f>
              <c:numCache>
                <c:formatCode>General</c:formatCode>
                <c:ptCount val="2"/>
                <c:pt idx="0">
                  <c:v>1</c:v>
                </c:pt>
                <c:pt idx="1">
                  <c:v>0.73083709617185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82-1042-9912-4A2D13441634}"/>
            </c:ext>
          </c:extLst>
        </c:ser>
        <c:ser>
          <c:idx val="1"/>
          <c:order val="1"/>
          <c:tx>
            <c:strRef>
              <c:f>'Nkx2.1'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kx2.1'!$D$36:$E$36</c:f>
                <c:numCache>
                  <c:formatCode>General</c:formatCode>
                  <c:ptCount val="2"/>
                  <c:pt idx="0">
                    <c:v>0.25122292853831812</c:v>
                  </c:pt>
                  <c:pt idx="1">
                    <c:v>0.285490616543990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kx2.1'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Nkx2.1'!$D$32:$E$32</c:f>
              <c:numCache>
                <c:formatCode>General</c:formatCode>
                <c:ptCount val="2"/>
                <c:pt idx="0">
                  <c:v>0.84797845200973754</c:v>
                </c:pt>
                <c:pt idx="1">
                  <c:v>0.940345440554677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C82-1042-9912-4A2D134416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Ccl2</a:t>
            </a:r>
          </a:p>
        </c:rich>
      </c:tx>
      <c:layout>
        <c:manualLayout>
          <c:xMode val="edge"/>
          <c:yMode val="edge"/>
          <c:x val="0.4367228915662650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1988371583422199E-2"/>
          <c:y val="0.23514455204107951"/>
          <c:w val="0.92362838703133121"/>
          <c:h val="0.6186888320945391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cl2'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cl2'!$D$35:$E$35</c:f>
                <c:numCache>
                  <c:formatCode>General</c:formatCode>
                  <c:ptCount val="2"/>
                  <c:pt idx="0">
                    <c:v>0.36932829461491323</c:v>
                  </c:pt>
                  <c:pt idx="1">
                    <c:v>5.55714993995805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cl2'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Ccl2'!$D$31:$E$31</c:f>
              <c:numCache>
                <c:formatCode>General</c:formatCode>
                <c:ptCount val="2"/>
                <c:pt idx="0">
                  <c:v>1</c:v>
                </c:pt>
                <c:pt idx="1">
                  <c:v>29.9259254540637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A7-3C49-9C93-5E4A6EA08CDD}"/>
            </c:ext>
          </c:extLst>
        </c:ser>
        <c:ser>
          <c:idx val="1"/>
          <c:order val="1"/>
          <c:tx>
            <c:strRef>
              <c:f>'Ccl2'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cl2'!$D$36:$E$36</c:f>
                <c:numCache>
                  <c:formatCode>General</c:formatCode>
                  <c:ptCount val="2"/>
                  <c:pt idx="0">
                    <c:v>0.53221795485955914</c:v>
                  </c:pt>
                  <c:pt idx="1">
                    <c:v>2.88664644144563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cl2'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Ccl2'!$D$32:$E$32</c:f>
              <c:numCache>
                <c:formatCode>General</c:formatCode>
                <c:ptCount val="2"/>
                <c:pt idx="0">
                  <c:v>1.9735589385886008</c:v>
                </c:pt>
                <c:pt idx="1">
                  <c:v>8.22735461138797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9A7-3C49-9C93-5E4A6EA08C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>
                <a:solidFill>
                  <a:schemeClr val="tx1"/>
                </a:solidFill>
              </a:rPr>
              <a:t>Ccl7</a:t>
            </a:r>
          </a:p>
        </c:rich>
      </c:tx>
      <c:layout>
        <c:manualLayout>
          <c:xMode val="edge"/>
          <c:yMode val="edge"/>
          <c:x val="0.4367228915662650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6371612968668776E-2"/>
          <c:y val="0.23771650730528995"/>
          <c:w val="0.92362838703133121"/>
          <c:h val="0.584894308157180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cl7'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cl7'!$D$35:$E$35</c:f>
                <c:numCache>
                  <c:formatCode>General</c:formatCode>
                  <c:ptCount val="2"/>
                  <c:pt idx="0">
                    <c:v>0.58899952092826702</c:v>
                  </c:pt>
                  <c:pt idx="1">
                    <c:v>2.02059265349910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cl7'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Ccl7'!$D$31:$E$31</c:f>
              <c:numCache>
                <c:formatCode>General</c:formatCode>
                <c:ptCount val="2"/>
                <c:pt idx="0">
                  <c:v>1</c:v>
                </c:pt>
                <c:pt idx="1">
                  <c:v>12.4390729864164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9F-ED44-925A-FB39DFBF7287}"/>
            </c:ext>
          </c:extLst>
        </c:ser>
        <c:ser>
          <c:idx val="1"/>
          <c:order val="1"/>
          <c:tx>
            <c:strRef>
              <c:f>'Ccl7'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cl7'!$D$36:$E$36</c:f>
                <c:numCache>
                  <c:formatCode>General</c:formatCode>
                  <c:ptCount val="2"/>
                  <c:pt idx="0">
                    <c:v>0.74695538384056848</c:v>
                  </c:pt>
                  <c:pt idx="1">
                    <c:v>1.03966642477606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cl7'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Ccl7'!$D$32:$E$32</c:f>
              <c:numCache>
                <c:formatCode>General</c:formatCode>
                <c:ptCount val="2"/>
                <c:pt idx="0">
                  <c:v>1.4517908699010376</c:v>
                </c:pt>
                <c:pt idx="1">
                  <c:v>4.11412037420123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B9F-ED44-925A-FB39DFBF72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>
                <a:solidFill>
                  <a:schemeClr val="tx1"/>
                </a:solidFill>
              </a:rPr>
              <a:t>Pax8</a:t>
            </a:r>
          </a:p>
        </c:rich>
      </c:tx>
      <c:layout>
        <c:manualLayout>
          <c:xMode val="edge"/>
          <c:yMode val="edge"/>
          <c:x val="0.4424304461942257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711589147254545"/>
          <c:y val="0.25804063333701677"/>
          <c:w val="0.91446281714785649"/>
          <c:h val="0.543034464441944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ax8'!$C$3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ax8'!$D$37:$E$37</c:f>
                <c:numCache>
                  <c:formatCode>General</c:formatCode>
                  <c:ptCount val="2"/>
                  <c:pt idx="0">
                    <c:v>0.46951121406015489</c:v>
                  </c:pt>
                  <c:pt idx="1">
                    <c:v>5.893915435393934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x8'!$D$32:$E$32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Pax8'!$D$33:$E$33</c:f>
              <c:numCache>
                <c:formatCode>General</c:formatCode>
                <c:ptCount val="2"/>
                <c:pt idx="0">
                  <c:v>1</c:v>
                </c:pt>
                <c:pt idx="1">
                  <c:v>0.732086917052795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66-7047-93F8-A4128C5D4E56}"/>
            </c:ext>
          </c:extLst>
        </c:ser>
        <c:ser>
          <c:idx val="1"/>
          <c:order val="1"/>
          <c:tx>
            <c:strRef>
              <c:f>'Pax8'!$C$34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ax8'!$D$38:$E$38</c:f>
                <c:numCache>
                  <c:formatCode>General</c:formatCode>
                  <c:ptCount val="2"/>
                  <c:pt idx="0">
                    <c:v>0.25859028268168832</c:v>
                  </c:pt>
                  <c:pt idx="1">
                    <c:v>0.120615889010523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ax8'!$D$32:$E$32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Pax8'!$D$34:$E$34</c:f>
              <c:numCache>
                <c:formatCode>General</c:formatCode>
                <c:ptCount val="2"/>
                <c:pt idx="0">
                  <c:v>1.9635896452386037</c:v>
                </c:pt>
                <c:pt idx="1">
                  <c:v>1.87544185722756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466-7047-93F8-A4128C5D4E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819072"/>
        <c:axId val="226066000"/>
      </c:barChart>
      <c:catAx>
        <c:axId val="160819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6066000"/>
        <c:crosses val="autoZero"/>
        <c:auto val="1"/>
        <c:lblAlgn val="ctr"/>
        <c:lblOffset val="100"/>
        <c:noMultiLvlLbl val="0"/>
      </c:catAx>
      <c:valAx>
        <c:axId val="226066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819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sz="1200" b="0"/>
            </a:pPr>
            <a:r>
              <a:rPr lang="en-US" sz="1200" b="0" dirty="0"/>
              <a:t>mPax8</a:t>
            </a:r>
          </a:p>
        </c:rich>
      </c:tx>
      <c:layout>
        <c:manualLayout>
          <c:xMode val="edge"/>
          <c:yMode val="edge"/>
          <c:x val="0.42707031140814622"/>
          <c:y val="4.8718623698880501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0858709009330059"/>
          <c:y val="0.25651267413359807"/>
          <c:w val="0.866260244255182"/>
          <c:h val="0.560834382932807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Pax8!$D$22</c:f>
              <c:strCache>
                <c:ptCount val="1"/>
                <c:pt idx="0">
                  <c:v>mGlis3</c:v>
                </c:pt>
              </c:strCache>
            </c:strRef>
          </c:tx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Pax8!$D$31:$D$36</c:f>
                <c:numCache>
                  <c:formatCode>General</c:formatCode>
                  <c:ptCount val="6"/>
                  <c:pt idx="0">
                    <c:v>8.4810718627789203E-2</c:v>
                  </c:pt>
                  <c:pt idx="1">
                    <c:v>4.1297802065009798E-2</c:v>
                  </c:pt>
                  <c:pt idx="2">
                    <c:v>1.8976528921885501E-2</c:v>
                  </c:pt>
                  <c:pt idx="3">
                    <c:v>4.3899870302489097E-2</c:v>
                  </c:pt>
                  <c:pt idx="4">
                    <c:v>1.1346476627595799E-2</c:v>
                  </c:pt>
                  <c:pt idx="5">
                    <c:v>3.170250631790799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mPax8!$C$23:$C$28</c:f>
              <c:strCache>
                <c:ptCount val="6"/>
                <c:pt idx="0">
                  <c:v>1W</c:v>
                </c:pt>
                <c:pt idx="1">
                  <c:v>2W</c:v>
                </c:pt>
                <c:pt idx="2">
                  <c:v>4W</c:v>
                </c:pt>
                <c:pt idx="3">
                  <c:v>6W</c:v>
                </c:pt>
                <c:pt idx="4">
                  <c:v>13W</c:v>
                </c:pt>
                <c:pt idx="5">
                  <c:v>10 M</c:v>
                </c:pt>
              </c:strCache>
            </c:strRef>
          </c:cat>
          <c:val>
            <c:numRef>
              <c:f>mPax8!$D$23:$D$28</c:f>
              <c:numCache>
                <c:formatCode>General</c:formatCode>
                <c:ptCount val="6"/>
                <c:pt idx="0">
                  <c:v>0.27952210051425003</c:v>
                </c:pt>
                <c:pt idx="1">
                  <c:v>0.197991909254738</c:v>
                </c:pt>
                <c:pt idx="2">
                  <c:v>0.16145542903202101</c:v>
                </c:pt>
                <c:pt idx="3">
                  <c:v>0.192502374352224</c:v>
                </c:pt>
                <c:pt idx="4">
                  <c:v>0.168550801565028</c:v>
                </c:pt>
                <c:pt idx="5">
                  <c:v>0.18488602513678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D6-AA40-BD6A-D3C39FC8C2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18976192"/>
        <c:axId val="418978944"/>
      </c:barChart>
      <c:catAx>
        <c:axId val="4189761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18978944"/>
        <c:crosses val="autoZero"/>
        <c:auto val="1"/>
        <c:lblAlgn val="ctr"/>
        <c:lblOffset val="100"/>
        <c:noMultiLvlLbl val="0"/>
      </c:catAx>
      <c:valAx>
        <c:axId val="418978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18976192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</a:rPr>
              <a:t>Nkx2.1</a:t>
            </a:r>
          </a:p>
        </c:rich>
      </c:tx>
      <c:layout>
        <c:manualLayout>
          <c:xMode val="edge"/>
          <c:yMode val="edge"/>
          <c:x val="0.33131962671332749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2759405074365702E-2"/>
          <c:y val="0.23340296004666083"/>
          <c:w val="0.91446281714785649"/>
          <c:h val="0.656589020122484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kx2.1'!$C$3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kx2.1'!$D$37:$E$37</c:f>
                <c:numCache>
                  <c:formatCode>General</c:formatCode>
                  <c:ptCount val="2"/>
                  <c:pt idx="0">
                    <c:v>0.13906977779932866</c:v>
                  </c:pt>
                  <c:pt idx="1">
                    <c:v>9.055348153900127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kx2.1'!$D$32:$E$32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Nkx2.1'!$D$33:$E$33</c:f>
              <c:numCache>
                <c:formatCode>General</c:formatCode>
                <c:ptCount val="2"/>
                <c:pt idx="0">
                  <c:v>1</c:v>
                </c:pt>
                <c:pt idx="1">
                  <c:v>1.00345316704669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41-324E-B2FD-A59BA44FEA9A}"/>
            </c:ext>
          </c:extLst>
        </c:ser>
        <c:ser>
          <c:idx val="1"/>
          <c:order val="1"/>
          <c:tx>
            <c:strRef>
              <c:f>'Nkx2.1'!$C$34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kx2.1'!$D$38:$E$38</c:f>
                <c:numCache>
                  <c:formatCode>General</c:formatCode>
                  <c:ptCount val="2"/>
                  <c:pt idx="0">
                    <c:v>0.15880056562680517</c:v>
                  </c:pt>
                  <c:pt idx="1">
                    <c:v>0.2756956181000283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Nkx2.1'!$D$32:$E$32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'Nkx2.1'!$D$34:$E$34</c:f>
              <c:numCache>
                <c:formatCode>General</c:formatCode>
                <c:ptCount val="2"/>
                <c:pt idx="0">
                  <c:v>1.2109765307388192</c:v>
                </c:pt>
                <c:pt idx="1">
                  <c:v>1.27546516783681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41-324E-B2FD-A59BA44FEA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819072"/>
        <c:axId val="226066000"/>
      </c:barChart>
      <c:catAx>
        <c:axId val="160819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6066000"/>
        <c:crosses val="autoZero"/>
        <c:auto val="1"/>
        <c:lblAlgn val="ctr"/>
        <c:lblOffset val="100"/>
        <c:noMultiLvlLbl val="0"/>
      </c:catAx>
      <c:valAx>
        <c:axId val="226066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819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i="1" dirty="0">
                <a:solidFill>
                  <a:schemeClr val="tx1"/>
                </a:solidFill>
              </a:rPr>
              <a:t>Foxe1</a:t>
            </a:r>
          </a:p>
        </c:rich>
      </c:tx>
      <c:layout>
        <c:manualLayout>
          <c:xMode val="edge"/>
          <c:yMode val="edge"/>
          <c:x val="0.4424304461942257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2759405074365702E-2"/>
          <c:y val="0.23803258967629046"/>
          <c:w val="0.91446281714785649"/>
          <c:h val="0.651959390492855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oxE1!$C$3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oxE1!$D$37:$E$37</c:f>
                <c:numCache>
                  <c:formatCode>General</c:formatCode>
                  <c:ptCount val="2"/>
                  <c:pt idx="0">
                    <c:v>0.20865460229439189</c:v>
                  </c:pt>
                  <c:pt idx="1">
                    <c:v>7.476894942071554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xE1!$D$32:$E$32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FoxE1!$D$33:$E$33</c:f>
              <c:numCache>
                <c:formatCode>General</c:formatCode>
                <c:ptCount val="2"/>
                <c:pt idx="0">
                  <c:v>1</c:v>
                </c:pt>
                <c:pt idx="1">
                  <c:v>0.98475969708858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61-6B45-B685-16699CEFC36B}"/>
            </c:ext>
          </c:extLst>
        </c:ser>
        <c:ser>
          <c:idx val="1"/>
          <c:order val="1"/>
          <c:tx>
            <c:strRef>
              <c:f>FoxE1!$C$34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oxE1!$D$38:$E$38</c:f>
                <c:numCache>
                  <c:formatCode>General</c:formatCode>
                  <c:ptCount val="2"/>
                  <c:pt idx="0">
                    <c:v>0.13487985728598326</c:v>
                  </c:pt>
                  <c:pt idx="1">
                    <c:v>9.02537270085334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xE1!$D$32:$E$32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FoxE1!$D$34:$E$34</c:f>
              <c:numCache>
                <c:formatCode>General</c:formatCode>
                <c:ptCount val="2"/>
                <c:pt idx="0">
                  <c:v>1.0436170533455251</c:v>
                </c:pt>
                <c:pt idx="1">
                  <c:v>1.0806173114416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361-6B45-B685-16699CEFC3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819072"/>
        <c:axId val="226066000"/>
      </c:barChart>
      <c:catAx>
        <c:axId val="160819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6066000"/>
        <c:crosses val="autoZero"/>
        <c:auto val="1"/>
        <c:lblAlgn val="ctr"/>
        <c:lblOffset val="100"/>
        <c:noMultiLvlLbl val="0"/>
      </c:catAx>
      <c:valAx>
        <c:axId val="226066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819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600" dirty="0" err="1">
                <a:solidFill>
                  <a:schemeClr val="tx1"/>
                </a:solidFill>
              </a:rPr>
              <a:t>GLISBS_Luc</a:t>
            </a:r>
            <a:endParaRPr lang="en-US" sz="160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41021364529806104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2759405074365702E-2"/>
          <c:y val="0.24279533912148182"/>
          <c:w val="0.91724059492563426"/>
          <c:h val="0.717176304087415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23:$H$30</c:f>
                <c:numCache>
                  <c:formatCode>General</c:formatCode>
                  <c:ptCount val="8"/>
                  <c:pt idx="0">
                    <c:v>0.25818269733356153</c:v>
                  </c:pt>
                  <c:pt idx="1">
                    <c:v>0.10947774869840433</c:v>
                  </c:pt>
                  <c:pt idx="2">
                    <c:v>0.82543324961435649</c:v>
                  </c:pt>
                  <c:pt idx="3">
                    <c:v>2.2819984925875851</c:v>
                  </c:pt>
                  <c:pt idx="4">
                    <c:v>0.37281887624735283</c:v>
                  </c:pt>
                  <c:pt idx="5">
                    <c:v>0.99570894573249791</c:v>
                  </c:pt>
                  <c:pt idx="6">
                    <c:v>2.1054723261134507</c:v>
                  </c:pt>
                  <c:pt idx="7">
                    <c:v>4.01025220577830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3:$A$30</c:f>
              <c:strCache>
                <c:ptCount val="8"/>
                <c:pt idx="0">
                  <c:v>S1</c:v>
                </c:pt>
                <c:pt idx="1">
                  <c:v>S2</c:v>
                </c:pt>
                <c:pt idx="2">
                  <c:v>S3</c:v>
                </c:pt>
                <c:pt idx="3">
                  <c:v>S4</c:v>
                </c:pt>
                <c:pt idx="4">
                  <c:v>S5</c:v>
                </c:pt>
                <c:pt idx="5">
                  <c:v>S6</c:v>
                </c:pt>
                <c:pt idx="6">
                  <c:v>S7</c:v>
                </c:pt>
                <c:pt idx="7">
                  <c:v>S8</c:v>
                </c:pt>
              </c:strCache>
            </c:strRef>
          </c:cat>
          <c:val>
            <c:numRef>
              <c:f>Sheet1!$G$23:$G$30</c:f>
              <c:numCache>
                <c:formatCode>General</c:formatCode>
                <c:ptCount val="8"/>
                <c:pt idx="0">
                  <c:v>1</c:v>
                </c:pt>
                <c:pt idx="1">
                  <c:v>1.402639302541494</c:v>
                </c:pt>
                <c:pt idx="2">
                  <c:v>7.2994237368139823</c:v>
                </c:pt>
                <c:pt idx="3">
                  <c:v>16.199684433052223</c:v>
                </c:pt>
                <c:pt idx="4">
                  <c:v>6.7154354461191499</c:v>
                </c:pt>
                <c:pt idx="5">
                  <c:v>17.0346487499848</c:v>
                </c:pt>
                <c:pt idx="6">
                  <c:v>7.4541325928510753</c:v>
                </c:pt>
                <c:pt idx="7">
                  <c:v>15.7994998901002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58-7E4C-BC14-D978D26942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53013519"/>
        <c:axId val="523053135"/>
      </c:barChart>
      <c:catAx>
        <c:axId val="8530135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3053135"/>
        <c:crosses val="autoZero"/>
        <c:auto val="1"/>
        <c:lblAlgn val="ctr"/>
        <c:lblOffset val="100"/>
        <c:noMultiLvlLbl val="0"/>
      </c:catAx>
      <c:valAx>
        <c:axId val="52305313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30135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i="1" dirty="0">
                <a:solidFill>
                  <a:schemeClr val="tx1"/>
                </a:solidFill>
              </a:rPr>
              <a:t>Glis3</a:t>
            </a:r>
            <a:r>
              <a:rPr lang="en-US" dirty="0">
                <a:solidFill>
                  <a:schemeClr val="tx1"/>
                </a:solidFill>
              </a:rPr>
              <a:t> E9-10</a:t>
            </a:r>
          </a:p>
        </c:rich>
      </c:tx>
      <c:layout>
        <c:manualLayout>
          <c:xMode val="edge"/>
          <c:yMode val="edge"/>
          <c:x val="0.4060275590551181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1176071741032372E-2"/>
          <c:y val="0.26137768225221103"/>
          <c:w val="0.90882392825896763"/>
          <c:h val="0.509470890149513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lis3!$G$16</c:f>
              <c:strCache>
                <c:ptCount val="1"/>
                <c:pt idx="0">
                  <c:v>AV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lis3!$H$17:$H$20</c:f>
                <c:numCache>
                  <c:formatCode>General</c:formatCode>
                  <c:ptCount val="4"/>
                  <c:pt idx="0">
                    <c:v>0.66358691932797775</c:v>
                  </c:pt>
                  <c:pt idx="1">
                    <c:v>0.23305574702942833</c:v>
                  </c:pt>
                  <c:pt idx="2">
                    <c:v>1.9236611592047516E-2</c:v>
                  </c:pt>
                  <c:pt idx="3">
                    <c:v>8.9899354126516152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lis3!$D$17:$D$19</c:f>
              <c:strCache>
                <c:ptCount val="3"/>
                <c:pt idx="0">
                  <c:v>WT islet</c:v>
                </c:pt>
                <c:pt idx="1">
                  <c:v>CKO islet</c:v>
                </c:pt>
                <c:pt idx="2">
                  <c:v>Liver</c:v>
                </c:pt>
              </c:strCache>
            </c:strRef>
          </c:cat>
          <c:val>
            <c:numRef>
              <c:f>Glis3!$G$17:$G$19</c:f>
              <c:numCache>
                <c:formatCode>General</c:formatCode>
                <c:ptCount val="3"/>
                <c:pt idx="0">
                  <c:v>1</c:v>
                </c:pt>
                <c:pt idx="1">
                  <c:v>0.59442229081210252</c:v>
                </c:pt>
                <c:pt idx="2">
                  <c:v>4.15246786372222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2B-CC4C-8EFA-EECD44BBEA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2783408"/>
        <c:axId val="862765696"/>
      </c:barChart>
      <c:catAx>
        <c:axId val="862783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65696"/>
        <c:crosses val="autoZero"/>
        <c:auto val="1"/>
        <c:lblAlgn val="ctr"/>
        <c:lblOffset val="100"/>
        <c:noMultiLvlLbl val="0"/>
      </c:catAx>
      <c:valAx>
        <c:axId val="862765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834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i="1" dirty="0">
                <a:solidFill>
                  <a:schemeClr val="tx1"/>
                </a:solidFill>
              </a:rPr>
              <a:t>Glis3 </a:t>
            </a:r>
            <a:r>
              <a:rPr lang="en-US" dirty="0">
                <a:solidFill>
                  <a:schemeClr val="tx1"/>
                </a:solidFill>
              </a:rPr>
              <a:t>E5</a:t>
            </a:r>
          </a:p>
        </c:rich>
      </c:tx>
      <c:layout>
        <c:manualLayout>
          <c:xMode val="edge"/>
          <c:yMode val="edge"/>
          <c:x val="0.47491890248519059"/>
          <c:y val="5.7509885360609624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456036745406823"/>
          <c:y val="0.20552990720820283"/>
          <c:w val="0.90882392825896763"/>
          <c:h val="0.528668567405382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lis3DE5!$G$16</c:f>
              <c:strCache>
                <c:ptCount val="1"/>
                <c:pt idx="0">
                  <c:v>AV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lis3DE5!$H$17:$H$20</c:f>
                <c:numCache>
                  <c:formatCode>General</c:formatCode>
                  <c:ptCount val="4"/>
                  <c:pt idx="0">
                    <c:v>0.49651175538808434</c:v>
                  </c:pt>
                  <c:pt idx="1">
                    <c:v>0.24129724959183105</c:v>
                  </c:pt>
                  <c:pt idx="2">
                    <c:v>5.7192150082942496E-3</c:v>
                  </c:pt>
                  <c:pt idx="3">
                    <c:v>1.2825721307469352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lis3DE5!$D$17:$D$19</c:f>
              <c:strCache>
                <c:ptCount val="3"/>
                <c:pt idx="0">
                  <c:v>WT islet</c:v>
                </c:pt>
                <c:pt idx="1">
                  <c:v>CKO islet</c:v>
                </c:pt>
                <c:pt idx="2">
                  <c:v>Liver</c:v>
                </c:pt>
              </c:strCache>
            </c:strRef>
          </c:cat>
          <c:val>
            <c:numRef>
              <c:f>Glis3DE5!$G$17:$G$19</c:f>
              <c:numCache>
                <c:formatCode>General</c:formatCode>
                <c:ptCount val="3"/>
                <c:pt idx="0">
                  <c:v>1</c:v>
                </c:pt>
                <c:pt idx="1">
                  <c:v>0.69256698774377912</c:v>
                </c:pt>
                <c:pt idx="2">
                  <c:v>2.340550290525734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33-524D-A19C-9CA2269F4C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2783408"/>
        <c:axId val="862765696"/>
      </c:barChart>
      <c:catAx>
        <c:axId val="862783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65696"/>
        <c:crosses val="autoZero"/>
        <c:auto val="1"/>
        <c:lblAlgn val="ctr"/>
        <c:lblOffset val="100"/>
        <c:noMultiLvlLbl val="0"/>
      </c:catAx>
      <c:valAx>
        <c:axId val="862765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834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i="1" dirty="0">
                <a:solidFill>
                  <a:schemeClr val="tx1"/>
                </a:solidFill>
              </a:rPr>
              <a:t>Ins1</a:t>
            </a:r>
          </a:p>
        </c:rich>
      </c:tx>
      <c:layout>
        <c:manualLayout>
          <c:xMode val="edge"/>
          <c:yMode val="edge"/>
          <c:x val="0.40328662828608541"/>
          <c:y val="5.080625159727309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1176071741032372E-2"/>
          <c:y val="0.26411211076675623"/>
          <c:w val="0.90882392825896763"/>
          <c:h val="0.505896825823438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Ins1!$G$16</c:f>
              <c:strCache>
                <c:ptCount val="1"/>
                <c:pt idx="0">
                  <c:v>AV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Ins1!$H$17:$H$20</c:f>
                <c:numCache>
                  <c:formatCode>General</c:formatCode>
                  <c:ptCount val="4"/>
                  <c:pt idx="0">
                    <c:v>0.45264095916082592</c:v>
                  </c:pt>
                  <c:pt idx="1">
                    <c:v>8.4825140234954383E-2</c:v>
                  </c:pt>
                  <c:pt idx="2">
                    <c:v>1.28276014933456E-6</c:v>
                  </c:pt>
                  <c:pt idx="3">
                    <c:v>1.4052744462602023E-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Ins1!$D$17:$D$19</c:f>
              <c:strCache>
                <c:ptCount val="3"/>
                <c:pt idx="0">
                  <c:v>WT islet</c:v>
                </c:pt>
                <c:pt idx="1">
                  <c:v>CKO islet</c:v>
                </c:pt>
                <c:pt idx="2">
                  <c:v>Liver</c:v>
                </c:pt>
              </c:strCache>
            </c:strRef>
          </c:cat>
          <c:val>
            <c:numRef>
              <c:f>Ins1!$G$17:$G$19</c:f>
              <c:numCache>
                <c:formatCode>General</c:formatCode>
                <c:ptCount val="3"/>
                <c:pt idx="0">
                  <c:v>1</c:v>
                </c:pt>
                <c:pt idx="1">
                  <c:v>0.82221017833617416</c:v>
                </c:pt>
                <c:pt idx="2">
                  <c:v>5.0890449286983721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35-004A-ACC4-46F3CADF43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2783408"/>
        <c:axId val="862765696"/>
      </c:barChart>
      <c:catAx>
        <c:axId val="862783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65696"/>
        <c:crosses val="autoZero"/>
        <c:auto val="1"/>
        <c:lblAlgn val="ctr"/>
        <c:lblOffset val="100"/>
        <c:noMultiLvlLbl val="0"/>
      </c:catAx>
      <c:valAx>
        <c:axId val="862765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834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i="1" dirty="0">
                <a:solidFill>
                  <a:schemeClr val="tx1"/>
                </a:solidFill>
              </a:rPr>
              <a:t>Ins2</a:t>
            </a:r>
          </a:p>
        </c:rich>
      </c:tx>
      <c:layout>
        <c:manualLayout>
          <c:xMode val="edge"/>
          <c:yMode val="edge"/>
          <c:x val="0.43486079250078391"/>
          <c:y val="5.9883006523004031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1176071741032372E-2"/>
          <c:y val="0.30006955380577427"/>
          <c:w val="0.90882392825896763"/>
          <c:h val="0.469939202245188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Ins2!$G$16</c:f>
              <c:strCache>
                <c:ptCount val="1"/>
                <c:pt idx="0">
                  <c:v>AV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Ins2!$H$17:$H$20</c:f>
                <c:numCache>
                  <c:formatCode>General</c:formatCode>
                  <c:ptCount val="4"/>
                  <c:pt idx="0">
                    <c:v>0.51598074691882501</c:v>
                  </c:pt>
                  <c:pt idx="1">
                    <c:v>0.17139514999552855</c:v>
                  </c:pt>
                  <c:pt idx="2">
                    <c:v>4.345394664626576E-7</c:v>
                  </c:pt>
                  <c:pt idx="3">
                    <c:v>1.8406999780321059E-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Ins2!$D$17:$D$19</c:f>
              <c:strCache>
                <c:ptCount val="3"/>
                <c:pt idx="0">
                  <c:v>WT islet</c:v>
                </c:pt>
                <c:pt idx="1">
                  <c:v>CKO islet</c:v>
                </c:pt>
                <c:pt idx="2">
                  <c:v>Liver</c:v>
                </c:pt>
              </c:strCache>
            </c:strRef>
          </c:cat>
          <c:val>
            <c:numRef>
              <c:f>Ins2!$G$17:$G$19</c:f>
              <c:numCache>
                <c:formatCode>General</c:formatCode>
                <c:ptCount val="3"/>
                <c:pt idx="0">
                  <c:v>1</c:v>
                </c:pt>
                <c:pt idx="1">
                  <c:v>0.82394977136223635</c:v>
                </c:pt>
                <c:pt idx="2">
                  <c:v>9.0248598757596592E-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C2-A24E-8711-A43A9252E1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62783408"/>
        <c:axId val="862765696"/>
      </c:barChart>
      <c:catAx>
        <c:axId val="862783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65696"/>
        <c:crosses val="autoZero"/>
        <c:auto val="1"/>
        <c:lblAlgn val="ctr"/>
        <c:lblOffset val="100"/>
        <c:noMultiLvlLbl val="0"/>
      </c:catAx>
      <c:valAx>
        <c:axId val="862765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27834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 dirty="0">
                <a:solidFill>
                  <a:schemeClr val="tx1"/>
                </a:solidFill>
              </a:rPr>
              <a:t>Slc5a5</a:t>
            </a:r>
          </a:p>
        </c:rich>
      </c:tx>
      <c:layout>
        <c:manualLayout>
          <c:xMode val="edge"/>
          <c:yMode val="edge"/>
          <c:x val="0.3881118766404199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6371612968668776E-2"/>
          <c:y val="0.24869947506561674"/>
          <c:w val="0.92362838703133121"/>
          <c:h val="0.619290901137357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is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is!$D$35:$E$35</c:f>
                <c:numCache>
                  <c:formatCode>General</c:formatCode>
                  <c:ptCount val="2"/>
                  <c:pt idx="0">
                    <c:v>0.64747652997416227</c:v>
                  </c:pt>
                  <c:pt idx="1">
                    <c:v>1.45963751710235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is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Nis!$D$31:$E$31</c:f>
              <c:numCache>
                <c:formatCode>General</c:formatCode>
                <c:ptCount val="2"/>
                <c:pt idx="0">
                  <c:v>1</c:v>
                </c:pt>
                <c:pt idx="1">
                  <c:v>6.14283987933009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04-B04F-82E5-0896C38EB84A}"/>
            </c:ext>
          </c:extLst>
        </c:ser>
        <c:ser>
          <c:idx val="1"/>
          <c:order val="1"/>
          <c:tx>
            <c:strRef>
              <c:f>Nis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Nis!$D$36:$E$36</c:f>
                <c:numCache>
                  <c:formatCode>General</c:formatCode>
                  <c:ptCount val="2"/>
                  <c:pt idx="0">
                    <c:v>4.4166412185770429E-2</c:v>
                  </c:pt>
                  <c:pt idx="1">
                    <c:v>1.859344079819713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is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Nis!$D$32:$E$32</c:f>
              <c:numCache>
                <c:formatCode>General</c:formatCode>
                <c:ptCount val="2"/>
                <c:pt idx="0">
                  <c:v>6.8875861054932291E-2</c:v>
                </c:pt>
                <c:pt idx="1">
                  <c:v>6.794772921934419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A04-B04F-82E5-0896C38EB8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400" i="1" dirty="0">
                <a:solidFill>
                  <a:schemeClr val="tx1"/>
                </a:solidFill>
              </a:rPr>
              <a:t>Slc26a4</a:t>
            </a:r>
          </a:p>
        </c:rich>
      </c:tx>
      <c:layout>
        <c:manualLayout>
          <c:xMode val="edge"/>
          <c:yMode val="edge"/>
          <c:x val="0.3325563210848643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6371612968668776E-2"/>
          <c:y val="0.26442751474247539"/>
          <c:w val="0.92362838703133121"/>
          <c:h val="0.632707843337764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endrin!$C$3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endrin!$D$35:$E$35</c:f>
                <c:numCache>
                  <c:formatCode>General</c:formatCode>
                  <c:ptCount val="2"/>
                  <c:pt idx="0">
                    <c:v>0.71026520549885452</c:v>
                  </c:pt>
                  <c:pt idx="1">
                    <c:v>6.52314328264237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endrin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Pendrin!$D$31:$E$31</c:f>
              <c:numCache>
                <c:formatCode>General</c:formatCode>
                <c:ptCount val="2"/>
                <c:pt idx="0">
                  <c:v>1</c:v>
                </c:pt>
                <c:pt idx="1">
                  <c:v>16.014169672841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03-7243-BFF9-35F341ADA01E}"/>
            </c:ext>
          </c:extLst>
        </c:ser>
        <c:ser>
          <c:idx val="1"/>
          <c:order val="1"/>
          <c:tx>
            <c:strRef>
              <c:f>Pendrin!$C$32</c:f>
              <c:strCache>
                <c:ptCount val="1"/>
                <c:pt idx="0">
                  <c:v>C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endrin!$D$36:$E$36</c:f>
                <c:numCache>
                  <c:formatCode>General</c:formatCode>
                  <c:ptCount val="2"/>
                  <c:pt idx="0">
                    <c:v>0.21429609749271941</c:v>
                  </c:pt>
                  <c:pt idx="1">
                    <c:v>1.00880430222380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endrin!$D$30:$E$30</c:f>
              <c:strCache>
                <c:ptCount val="2"/>
                <c:pt idx="0">
                  <c:v>ND</c:v>
                </c:pt>
                <c:pt idx="1">
                  <c:v>LID</c:v>
                </c:pt>
              </c:strCache>
            </c:strRef>
          </c:cat>
          <c:val>
            <c:numRef>
              <c:f>Pendrin!$D$32:$E$32</c:f>
              <c:numCache>
                <c:formatCode>General</c:formatCode>
                <c:ptCount val="2"/>
                <c:pt idx="0">
                  <c:v>0.55038748066579679</c:v>
                </c:pt>
                <c:pt idx="1">
                  <c:v>2.2538914251828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003-7243-BFF9-35F341ADA0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017168"/>
        <c:axId val="164023344"/>
      </c:barChart>
      <c:catAx>
        <c:axId val="164017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23344"/>
        <c:crosses val="autoZero"/>
        <c:auto val="1"/>
        <c:lblAlgn val="ctr"/>
        <c:lblOffset val="100"/>
        <c:noMultiLvlLbl val="0"/>
      </c:catAx>
      <c:valAx>
        <c:axId val="164023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017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EA01DF-BCB6-C64F-9553-0C4FDDDAA886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88A016-8440-DC4A-81D2-24C61998C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199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88A016-8440-DC4A-81D2-24C61998C8E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5177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286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067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020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381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596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777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940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748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602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823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432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78DA1-096E-6641-B142-555FA7A9B01F}" type="datetimeFigureOut">
              <a:rPr lang="en-US" smtClean="0"/>
              <a:t>10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4AA65-3F9A-2048-B557-09F42F7809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276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5" Type="http://schemas.openxmlformats.org/officeDocument/2006/relationships/image" Target="../media/image9.jpg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0.jpg"/><Relationship Id="rId18" Type="http://schemas.openxmlformats.org/officeDocument/2006/relationships/image" Target="../media/image25.jpg"/><Relationship Id="rId26" Type="http://schemas.openxmlformats.org/officeDocument/2006/relationships/image" Target="../media/image33.jpg"/><Relationship Id="rId3" Type="http://schemas.openxmlformats.org/officeDocument/2006/relationships/image" Target="../media/image10.jpg"/><Relationship Id="rId21" Type="http://schemas.openxmlformats.org/officeDocument/2006/relationships/image" Target="../media/image28.jpg"/><Relationship Id="rId7" Type="http://schemas.openxmlformats.org/officeDocument/2006/relationships/image" Target="../media/image14.jpg"/><Relationship Id="rId12" Type="http://schemas.openxmlformats.org/officeDocument/2006/relationships/image" Target="../media/image19.jpg"/><Relationship Id="rId17" Type="http://schemas.openxmlformats.org/officeDocument/2006/relationships/image" Target="../media/image24.jpg"/><Relationship Id="rId25" Type="http://schemas.openxmlformats.org/officeDocument/2006/relationships/image" Target="../media/image32.jpg"/><Relationship Id="rId33" Type="http://schemas.openxmlformats.org/officeDocument/2006/relationships/image" Target="../media/image40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3.jpg"/><Relationship Id="rId20" Type="http://schemas.openxmlformats.org/officeDocument/2006/relationships/image" Target="../media/image27.jpg"/><Relationship Id="rId29" Type="http://schemas.openxmlformats.org/officeDocument/2006/relationships/image" Target="../media/image36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g"/><Relationship Id="rId11" Type="http://schemas.openxmlformats.org/officeDocument/2006/relationships/image" Target="../media/image18.jpg"/><Relationship Id="rId24" Type="http://schemas.openxmlformats.org/officeDocument/2006/relationships/image" Target="../media/image31.jpg"/><Relationship Id="rId32" Type="http://schemas.openxmlformats.org/officeDocument/2006/relationships/image" Target="../media/image39.jpg"/><Relationship Id="rId5" Type="http://schemas.openxmlformats.org/officeDocument/2006/relationships/image" Target="../media/image12.jpg"/><Relationship Id="rId15" Type="http://schemas.openxmlformats.org/officeDocument/2006/relationships/image" Target="../media/image22.png"/><Relationship Id="rId23" Type="http://schemas.openxmlformats.org/officeDocument/2006/relationships/image" Target="../media/image30.jpg"/><Relationship Id="rId28" Type="http://schemas.openxmlformats.org/officeDocument/2006/relationships/image" Target="../media/image35.jpg"/><Relationship Id="rId10" Type="http://schemas.openxmlformats.org/officeDocument/2006/relationships/image" Target="../media/image17.jpg"/><Relationship Id="rId19" Type="http://schemas.openxmlformats.org/officeDocument/2006/relationships/image" Target="../media/image26.jpg"/><Relationship Id="rId31" Type="http://schemas.openxmlformats.org/officeDocument/2006/relationships/image" Target="../media/image38.jpg"/><Relationship Id="rId4" Type="http://schemas.openxmlformats.org/officeDocument/2006/relationships/image" Target="../media/image11.jpg"/><Relationship Id="rId9" Type="http://schemas.openxmlformats.org/officeDocument/2006/relationships/image" Target="../media/image16.jpg"/><Relationship Id="rId14" Type="http://schemas.openxmlformats.org/officeDocument/2006/relationships/image" Target="../media/image21.jpg"/><Relationship Id="rId22" Type="http://schemas.openxmlformats.org/officeDocument/2006/relationships/image" Target="../media/image29.jpg"/><Relationship Id="rId27" Type="http://schemas.openxmlformats.org/officeDocument/2006/relationships/image" Target="../media/image34.jpg"/><Relationship Id="rId30" Type="http://schemas.openxmlformats.org/officeDocument/2006/relationships/image" Target="../media/image37.jpg"/><Relationship Id="rId8" Type="http://schemas.openxmlformats.org/officeDocument/2006/relationships/image" Target="../media/image15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13" Type="http://schemas.openxmlformats.org/officeDocument/2006/relationships/image" Target="../media/image47.png"/><Relationship Id="rId18" Type="http://schemas.openxmlformats.org/officeDocument/2006/relationships/chart" Target="../charts/chart7.xml"/><Relationship Id="rId3" Type="http://schemas.openxmlformats.org/officeDocument/2006/relationships/image" Target="../media/image42.png"/><Relationship Id="rId7" Type="http://schemas.openxmlformats.org/officeDocument/2006/relationships/image" Target="../media/image44.png"/><Relationship Id="rId12" Type="http://schemas.microsoft.com/office/2007/relationships/hdphoto" Target="../media/hdphoto10.wdp"/><Relationship Id="rId17" Type="http://schemas.openxmlformats.org/officeDocument/2006/relationships/chart" Target="../charts/chart6.xml"/><Relationship Id="rId2" Type="http://schemas.openxmlformats.org/officeDocument/2006/relationships/image" Target="../media/image41.emf"/><Relationship Id="rId16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6" Type="http://schemas.microsoft.com/office/2007/relationships/hdphoto" Target="../media/hdphoto7.wdp"/><Relationship Id="rId11" Type="http://schemas.openxmlformats.org/officeDocument/2006/relationships/image" Target="../media/image46.png"/><Relationship Id="rId5" Type="http://schemas.openxmlformats.org/officeDocument/2006/relationships/image" Target="../media/image43.png"/><Relationship Id="rId15" Type="http://schemas.openxmlformats.org/officeDocument/2006/relationships/chart" Target="../charts/chart4.xml"/><Relationship Id="rId10" Type="http://schemas.microsoft.com/office/2007/relationships/hdphoto" Target="../media/hdphoto9.wdp"/><Relationship Id="rId4" Type="http://schemas.microsoft.com/office/2007/relationships/hdphoto" Target="../media/hdphoto6.wdp"/><Relationship Id="rId9" Type="http://schemas.openxmlformats.org/officeDocument/2006/relationships/image" Target="../media/image45.png"/><Relationship Id="rId14" Type="http://schemas.microsoft.com/office/2007/relationships/hdphoto" Target="../media/hdphoto11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4.xml"/><Relationship Id="rId3" Type="http://schemas.openxmlformats.org/officeDocument/2006/relationships/chart" Target="../charts/chart9.xml"/><Relationship Id="rId7" Type="http://schemas.openxmlformats.org/officeDocument/2006/relationships/chart" Target="../charts/chart13.xml"/><Relationship Id="rId12" Type="http://schemas.openxmlformats.org/officeDocument/2006/relationships/chart" Target="../charts/chart18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2.xml"/><Relationship Id="rId11" Type="http://schemas.openxmlformats.org/officeDocument/2006/relationships/chart" Target="../charts/chart17.xml"/><Relationship Id="rId5" Type="http://schemas.openxmlformats.org/officeDocument/2006/relationships/chart" Target="../charts/chart11.xml"/><Relationship Id="rId10" Type="http://schemas.openxmlformats.org/officeDocument/2006/relationships/chart" Target="../charts/chart16.xml"/><Relationship Id="rId4" Type="http://schemas.openxmlformats.org/officeDocument/2006/relationships/chart" Target="../charts/chart10.xml"/><Relationship Id="rId9" Type="http://schemas.openxmlformats.org/officeDocument/2006/relationships/chart" Target="../charts/chart1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5203652-CDAF-9544-805B-EC137C0059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24160" y="727309"/>
            <a:ext cx="1188720" cy="118872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71466C8-B19D-2B40-B8DB-6CE159D602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78351" y="727309"/>
            <a:ext cx="1188720" cy="11887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BECCF9B-5303-F946-8A29-42FF2A9B201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83965" y="734791"/>
            <a:ext cx="1188720" cy="11887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0958EDC-0D07-5D46-AB20-D61AFDF370D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20584" y="3834497"/>
            <a:ext cx="1188720" cy="118872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8C861EE-85BF-CC4B-94AE-080FCCFEDC1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180806" y="3834497"/>
            <a:ext cx="1188720" cy="118872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3E79C8B-924D-254D-B14F-8DE3CD1B6CB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80096" y="3834497"/>
            <a:ext cx="1188720" cy="118872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357E62A0-7AF4-DE41-9E70-A3524D498960}"/>
              </a:ext>
            </a:extLst>
          </p:cNvPr>
          <p:cNvSpPr txBox="1"/>
          <p:nvPr/>
        </p:nvSpPr>
        <p:spPr>
          <a:xfrm>
            <a:off x="2934225" y="357977"/>
            <a:ext cx="708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FA00"/>
                </a:solidFill>
              </a:rPr>
              <a:t>GLIS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4B7801-4FB3-6B4A-A928-0B77958DFF4D}"/>
              </a:ext>
            </a:extLst>
          </p:cNvPr>
          <p:cNvSpPr txBox="1"/>
          <p:nvPr/>
        </p:nvSpPr>
        <p:spPr>
          <a:xfrm>
            <a:off x="2925632" y="3470171"/>
            <a:ext cx="708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00FA00"/>
                </a:solidFill>
              </a:rPr>
              <a:t>GLIS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3C5F14A-A8B5-9442-946E-248C84F169A7}"/>
              </a:ext>
            </a:extLst>
          </p:cNvPr>
          <p:cNvSpPr txBox="1"/>
          <p:nvPr/>
        </p:nvSpPr>
        <p:spPr>
          <a:xfrm>
            <a:off x="4113887" y="357977"/>
            <a:ext cx="712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CDH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2078A5D-368B-484D-9802-0DE8AE808661}"/>
              </a:ext>
            </a:extLst>
          </p:cNvPr>
          <p:cNvSpPr txBox="1"/>
          <p:nvPr/>
        </p:nvSpPr>
        <p:spPr>
          <a:xfrm>
            <a:off x="4147491" y="3470171"/>
            <a:ext cx="6565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PAX8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E8A1130-BBC8-EF4C-9BDC-A4673713086C}"/>
              </a:ext>
            </a:extLst>
          </p:cNvPr>
          <p:cNvSpPr/>
          <p:nvPr/>
        </p:nvSpPr>
        <p:spPr>
          <a:xfrm>
            <a:off x="4891759" y="347615"/>
            <a:ext cx="18644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FA00"/>
                </a:solidFill>
              </a:rPr>
              <a:t>GLIS3</a:t>
            </a:r>
            <a:r>
              <a:rPr lang="en-US" dirty="0"/>
              <a:t>/</a:t>
            </a:r>
            <a:r>
              <a:rPr lang="en-US" dirty="0">
                <a:solidFill>
                  <a:srgbClr val="FF0000"/>
                </a:solidFill>
              </a:rPr>
              <a:t>CDH1</a:t>
            </a:r>
            <a:r>
              <a:rPr lang="en-US" dirty="0"/>
              <a:t>/</a:t>
            </a:r>
            <a:r>
              <a:rPr lang="en-US" dirty="0">
                <a:solidFill>
                  <a:srgbClr val="0070C0"/>
                </a:solidFill>
              </a:rPr>
              <a:t>DAPI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27CAF18-7CF4-9448-AA86-12B69D600B3F}"/>
              </a:ext>
            </a:extLst>
          </p:cNvPr>
          <p:cNvSpPr/>
          <p:nvPr/>
        </p:nvSpPr>
        <p:spPr>
          <a:xfrm>
            <a:off x="4894547" y="3470171"/>
            <a:ext cx="18089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FA00"/>
                </a:solidFill>
              </a:rPr>
              <a:t>GLIS3</a:t>
            </a:r>
            <a:r>
              <a:rPr lang="en-US" dirty="0"/>
              <a:t>/</a:t>
            </a:r>
            <a:r>
              <a:rPr lang="en-US" dirty="0">
                <a:solidFill>
                  <a:srgbClr val="FF0000"/>
                </a:solidFill>
              </a:rPr>
              <a:t>PAX8</a:t>
            </a:r>
            <a:r>
              <a:rPr lang="en-US" dirty="0"/>
              <a:t>/</a:t>
            </a:r>
            <a:r>
              <a:rPr lang="en-US" dirty="0">
                <a:solidFill>
                  <a:srgbClr val="0070C0"/>
                </a:solidFill>
              </a:rPr>
              <a:t>DAP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C349070-F357-3E41-8667-66ACDE0737BA}"/>
              </a:ext>
            </a:extLst>
          </p:cNvPr>
          <p:cNvSpPr txBox="1"/>
          <p:nvPr/>
        </p:nvSpPr>
        <p:spPr>
          <a:xfrm>
            <a:off x="1929213" y="1159950"/>
            <a:ext cx="705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13.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A14D5CD-4877-0042-A320-6CDEE3962697}"/>
              </a:ext>
            </a:extLst>
          </p:cNvPr>
          <p:cNvSpPr txBox="1"/>
          <p:nvPr/>
        </p:nvSpPr>
        <p:spPr>
          <a:xfrm>
            <a:off x="1929213" y="2308837"/>
            <a:ext cx="705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14.5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0CFB1E6-6F48-8045-B0E0-841A022F57FB}"/>
              </a:ext>
            </a:extLst>
          </p:cNvPr>
          <p:cNvSpPr/>
          <p:nvPr/>
        </p:nvSpPr>
        <p:spPr>
          <a:xfrm>
            <a:off x="7408324" y="6483728"/>
            <a:ext cx="16385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Batang" panose="02030600000101010101" pitchFamily="18" charset="-127"/>
              </a:rPr>
              <a:t>Supplementary Fig. 1</a:t>
            </a:r>
            <a:r>
              <a:rPr lang="en-US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 </a:t>
            </a:r>
            <a:endParaRPr lang="en-US" sz="1200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81E2B80-7FE9-BD70-5AA9-BFCC0D8F9076}"/>
              </a:ext>
            </a:extLst>
          </p:cNvPr>
          <p:cNvCxnSpPr>
            <a:cxnSpLocks/>
          </p:cNvCxnSpPr>
          <p:nvPr/>
        </p:nvCxnSpPr>
        <p:spPr>
          <a:xfrm>
            <a:off x="6032227" y="1832255"/>
            <a:ext cx="27432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D977133-F077-D876-2964-2728EB186655}"/>
              </a:ext>
            </a:extLst>
          </p:cNvPr>
          <p:cNvCxnSpPr>
            <a:cxnSpLocks/>
          </p:cNvCxnSpPr>
          <p:nvPr/>
        </p:nvCxnSpPr>
        <p:spPr>
          <a:xfrm>
            <a:off x="6032227" y="4950385"/>
            <a:ext cx="27432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 descr="A dark green background with black spots&#10;&#10;Description automatically generated">
            <a:extLst>
              <a:ext uri="{FF2B5EF4-FFF2-40B4-BE49-F238E27FC236}">
                <a16:creationId xmlns:a16="http://schemas.microsoft.com/office/drawing/2014/main" id="{F3FB960D-7423-E02D-21F8-5374799CE6F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73829" y="1951767"/>
            <a:ext cx="1188720" cy="1188720"/>
          </a:xfrm>
          <a:prstGeom prst="rect">
            <a:avLst/>
          </a:prstGeom>
        </p:spPr>
      </p:pic>
      <p:pic>
        <p:nvPicPr>
          <p:cNvPr id="14" name="Picture 13" descr="A red light on a black background&#10;&#10;Description automatically generated">
            <a:extLst>
              <a:ext uri="{FF2B5EF4-FFF2-40B4-BE49-F238E27FC236}">
                <a16:creationId xmlns:a16="http://schemas.microsoft.com/office/drawing/2014/main" id="{0F98503C-FA84-45DA-BA0F-E0649B0D0FD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18812" y="1957931"/>
            <a:ext cx="1188720" cy="1188720"/>
          </a:xfrm>
          <a:prstGeom prst="rect">
            <a:avLst/>
          </a:prstGeom>
        </p:spPr>
      </p:pic>
      <p:pic>
        <p:nvPicPr>
          <p:cNvPr id="24" name="Picture 23" descr="A blue and red cells&#10;&#10;Description automatically generated">
            <a:extLst>
              <a:ext uri="{FF2B5EF4-FFF2-40B4-BE49-F238E27FC236}">
                <a16:creationId xmlns:a16="http://schemas.microsoft.com/office/drawing/2014/main" id="{414D8838-B2B7-82E0-688B-013FE82D1F8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178661" y="1951767"/>
            <a:ext cx="1188720" cy="1188720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8FA370FF-CAF6-343E-5171-1245DA6BB847}"/>
              </a:ext>
            </a:extLst>
          </p:cNvPr>
          <p:cNvSpPr txBox="1"/>
          <p:nvPr/>
        </p:nvSpPr>
        <p:spPr>
          <a:xfrm>
            <a:off x="1929213" y="4172806"/>
            <a:ext cx="7056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13.5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F78B0EC4-4B2F-A06C-62BE-620E93964B71}"/>
              </a:ext>
            </a:extLst>
          </p:cNvPr>
          <p:cNvCxnSpPr>
            <a:cxnSpLocks/>
          </p:cNvCxnSpPr>
          <p:nvPr/>
        </p:nvCxnSpPr>
        <p:spPr>
          <a:xfrm>
            <a:off x="6053059" y="3076672"/>
            <a:ext cx="27432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43513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A picture containing text, fabric&#10;&#10;Description automatically generated">
            <a:extLst>
              <a:ext uri="{FF2B5EF4-FFF2-40B4-BE49-F238E27FC236}">
                <a16:creationId xmlns:a16="http://schemas.microsoft.com/office/drawing/2014/main" id="{C3BF11AA-D3B2-D523-C5EB-08C6281FF2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7526" y="391854"/>
            <a:ext cx="2844994" cy="1405629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ADA320E-B010-FC45-96C0-979CF37BB731}"/>
              </a:ext>
            </a:extLst>
          </p:cNvPr>
          <p:cNvSpPr txBox="1"/>
          <p:nvPr/>
        </p:nvSpPr>
        <p:spPr>
          <a:xfrm>
            <a:off x="1569437" y="33764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9B5E851-294B-EB46-B20D-9FF92A5A816A}"/>
              </a:ext>
            </a:extLst>
          </p:cNvPr>
          <p:cNvSpPr txBox="1"/>
          <p:nvPr/>
        </p:nvSpPr>
        <p:spPr>
          <a:xfrm>
            <a:off x="2967680" y="360503"/>
            <a:ext cx="838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Glis3KO2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D92B87A0-2C87-BE49-98DB-D0E41B769F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12031" y="364342"/>
            <a:ext cx="914400" cy="9144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E257E5E2-BC49-1845-AD64-70548F5DBF7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50306" y="364342"/>
            <a:ext cx="914400" cy="9144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7BEA30A-A9F9-F449-9124-5F6709CBD7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96998" y="364342"/>
            <a:ext cx="914400" cy="9144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680822AA-2D90-034E-9CC8-22AEBF7F001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12031" y="1323093"/>
            <a:ext cx="914400" cy="9144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8264835B-BAF9-844F-AAB2-1F7A10194F5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50306" y="1323093"/>
            <a:ext cx="914400" cy="9144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FDACF30-BA73-2246-83A3-1A10B7722B9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02137" y="1323093"/>
            <a:ext cx="914400" cy="91440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7C6EE058-EA35-3D43-86BB-290EAA537F24}"/>
              </a:ext>
            </a:extLst>
          </p:cNvPr>
          <p:cNvSpPr txBox="1"/>
          <p:nvPr/>
        </p:nvSpPr>
        <p:spPr>
          <a:xfrm>
            <a:off x="4640760" y="364342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484AB80-819B-0C4F-A89F-83333E3BF133}"/>
              </a:ext>
            </a:extLst>
          </p:cNvPr>
          <p:cNvSpPr txBox="1"/>
          <p:nvPr/>
        </p:nvSpPr>
        <p:spPr>
          <a:xfrm>
            <a:off x="4635527" y="1323093"/>
            <a:ext cx="838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Glis3KO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0957423-C5D8-CB41-9544-B4B7A7CC27D7}"/>
              </a:ext>
            </a:extLst>
          </p:cNvPr>
          <p:cNvSpPr txBox="1"/>
          <p:nvPr/>
        </p:nvSpPr>
        <p:spPr>
          <a:xfrm>
            <a:off x="4877806" y="99841"/>
            <a:ext cx="5529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FA00"/>
                </a:solidFill>
              </a:rPr>
              <a:t>PAX8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5FFC9ED-1DD8-6C4E-B4A1-9D29429A2CE9}"/>
              </a:ext>
            </a:extLst>
          </p:cNvPr>
          <p:cNvSpPr txBox="1"/>
          <p:nvPr/>
        </p:nvSpPr>
        <p:spPr>
          <a:xfrm>
            <a:off x="5765695" y="99841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CDH1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1D0AE134-D85C-724C-BA8E-6E942B72071C}"/>
              </a:ext>
            </a:extLst>
          </p:cNvPr>
          <p:cNvSpPr/>
          <p:nvPr/>
        </p:nvSpPr>
        <p:spPr>
          <a:xfrm>
            <a:off x="6369678" y="99841"/>
            <a:ext cx="14512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FA00"/>
                </a:solidFill>
              </a:rPr>
              <a:t>PAX8</a:t>
            </a:r>
            <a:r>
              <a:rPr lang="en-US" sz="1400" dirty="0"/>
              <a:t>/</a:t>
            </a:r>
            <a:r>
              <a:rPr lang="en-US" sz="1400" dirty="0">
                <a:solidFill>
                  <a:srgbClr val="FF0000"/>
                </a:solidFill>
              </a:rPr>
              <a:t>CDH1</a:t>
            </a:r>
            <a:r>
              <a:rPr lang="en-US" sz="1400" dirty="0"/>
              <a:t>/</a:t>
            </a:r>
            <a:r>
              <a:rPr lang="en-US" sz="1400" dirty="0">
                <a:solidFill>
                  <a:srgbClr val="0070C0"/>
                </a:solidFill>
              </a:rPr>
              <a:t>DAPI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49C255B4-B9F7-1643-90D3-5792CAA7C6D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23791" y="3512380"/>
            <a:ext cx="914400" cy="9144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DCD0E50-1FDE-4549-A5F0-3327022607E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17918" y="3512380"/>
            <a:ext cx="914400" cy="9144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1AFFC617-F8C2-2C48-B374-62535F8952A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73547" y="3512380"/>
            <a:ext cx="914400" cy="914400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6416370E-1236-C042-B146-8462845882B0}"/>
              </a:ext>
            </a:extLst>
          </p:cNvPr>
          <p:cNvGrpSpPr/>
          <p:nvPr/>
        </p:nvGrpSpPr>
        <p:grpSpPr>
          <a:xfrm>
            <a:off x="1609913" y="2548798"/>
            <a:ext cx="2819573" cy="914400"/>
            <a:chOff x="1616287" y="3488804"/>
            <a:chExt cx="2819573" cy="914400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80E2E8B1-529A-A343-A275-47E74EECDF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521460" y="3488804"/>
              <a:ext cx="914400" cy="914400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448C6D71-9C08-524B-B1B1-BD370986A9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616287" y="3488804"/>
              <a:ext cx="914400" cy="914400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96B0A52D-16C9-3944-8187-37DCEA74C1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566892" y="3488804"/>
              <a:ext cx="914400" cy="914400"/>
            </a:xfrm>
            <a:prstGeom prst="rect">
              <a:avLst/>
            </a:prstGeom>
          </p:spPr>
        </p:pic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E21066E3-2F49-E940-8249-AA80CFAA9C2D}"/>
              </a:ext>
            </a:extLst>
          </p:cNvPr>
          <p:cNvSpPr txBox="1"/>
          <p:nvPr/>
        </p:nvSpPr>
        <p:spPr>
          <a:xfrm>
            <a:off x="1569852" y="253919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F5A33A1-D933-F149-A123-B57DD6F993BF}"/>
              </a:ext>
            </a:extLst>
          </p:cNvPr>
          <p:cNvSpPr txBox="1"/>
          <p:nvPr/>
        </p:nvSpPr>
        <p:spPr>
          <a:xfrm>
            <a:off x="1568100" y="3486379"/>
            <a:ext cx="838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Glis3KO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329CCB9-CEF9-BA4D-81CD-866FDFCEF6AF}"/>
              </a:ext>
            </a:extLst>
          </p:cNvPr>
          <p:cNvSpPr txBox="1"/>
          <p:nvPr/>
        </p:nvSpPr>
        <p:spPr>
          <a:xfrm>
            <a:off x="1620370" y="2237581"/>
            <a:ext cx="713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FA00"/>
                </a:solidFill>
              </a:rPr>
              <a:t>NKX2.1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86BB061-4E2B-3040-A451-539F8977E670}"/>
              </a:ext>
            </a:extLst>
          </p:cNvPr>
          <p:cNvSpPr/>
          <p:nvPr/>
        </p:nvSpPr>
        <p:spPr>
          <a:xfrm>
            <a:off x="3342891" y="2237581"/>
            <a:ext cx="11326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FA00"/>
                </a:solidFill>
              </a:rPr>
              <a:t>NKX2.1</a:t>
            </a:r>
            <a:r>
              <a:rPr lang="en-US" sz="1400" dirty="0"/>
              <a:t>/</a:t>
            </a:r>
            <a:r>
              <a:rPr lang="en-US" sz="1400" dirty="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146C8AD9-EC49-0D42-B5A8-33391BB086B0}"/>
              </a:ext>
            </a:extLst>
          </p:cNvPr>
          <p:cNvSpPr/>
          <p:nvPr/>
        </p:nvSpPr>
        <p:spPr>
          <a:xfrm>
            <a:off x="2589757" y="2237581"/>
            <a:ext cx="5346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00FF"/>
                </a:solidFill>
              </a:rPr>
              <a:t>DAPI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486F0F4-8941-8915-A0D4-F6358E762DDC}"/>
              </a:ext>
            </a:extLst>
          </p:cNvPr>
          <p:cNvGrpSpPr/>
          <p:nvPr/>
        </p:nvGrpSpPr>
        <p:grpSpPr>
          <a:xfrm>
            <a:off x="4651002" y="2246935"/>
            <a:ext cx="2974705" cy="2157697"/>
            <a:chOff x="4688545" y="65627"/>
            <a:chExt cx="2974705" cy="2157697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A15A6FF6-C8EA-9549-851B-FBA9E2641343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719497" y="360503"/>
              <a:ext cx="914400" cy="914400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94D6CA49-8D8F-2F42-AAD4-2DA1648131B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6629421" y="360503"/>
              <a:ext cx="914400" cy="914400"/>
            </a:xfrm>
            <a:prstGeom prst="rect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B3A0D585-15E2-D648-9BBF-4DCA6491FAC3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674776" y="360503"/>
              <a:ext cx="914400" cy="914400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845710FD-A19F-C441-8310-E720256884C9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6629421" y="1308924"/>
              <a:ext cx="914400" cy="914400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13D40EE8-954D-DF43-BFBE-D11DC32AC096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720735" y="1308924"/>
              <a:ext cx="914400" cy="914400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352379AA-C06F-3C4A-9714-7AB796B30DF7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5681038" y="1308924"/>
              <a:ext cx="914400" cy="914400"/>
            </a:xfrm>
            <a:prstGeom prst="rect">
              <a:avLst/>
            </a:prstGeom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1C413AD-3CF4-CE40-AD8B-946797A79682}"/>
                </a:ext>
              </a:extLst>
            </p:cNvPr>
            <p:cNvSpPr txBox="1"/>
            <p:nvPr/>
          </p:nvSpPr>
          <p:spPr>
            <a:xfrm>
              <a:off x="4688545" y="1308924"/>
              <a:ext cx="838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</a:rPr>
                <a:t>Glis3KO2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718BF4C-E2A2-0A43-ADC8-D225FC19A703}"/>
                </a:ext>
              </a:extLst>
            </p:cNvPr>
            <p:cNvSpPr txBox="1"/>
            <p:nvPr/>
          </p:nvSpPr>
          <p:spPr>
            <a:xfrm>
              <a:off x="4769725" y="65627"/>
              <a:ext cx="6864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rgbClr val="00FA00"/>
                  </a:solidFill>
                </a:rPr>
                <a:t>CDH16</a:t>
              </a: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48B3EEA7-242A-9245-9A11-F83D1DDDF400}"/>
                </a:ext>
              </a:extLst>
            </p:cNvPr>
            <p:cNvSpPr/>
            <p:nvPr/>
          </p:nvSpPr>
          <p:spPr>
            <a:xfrm>
              <a:off x="6557883" y="99655"/>
              <a:ext cx="110536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rgbClr val="00FA00"/>
                  </a:solidFill>
                </a:rPr>
                <a:t>CDH16</a:t>
              </a:r>
              <a:r>
                <a:rPr lang="en-US" sz="1400" dirty="0"/>
                <a:t>/</a:t>
              </a:r>
              <a:r>
                <a:rPr lang="en-US" sz="1400" dirty="0">
                  <a:solidFill>
                    <a:srgbClr val="0000FF"/>
                  </a:solidFill>
                </a:rPr>
                <a:t>DAPI</a:t>
              </a: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D0684C27-2E0C-3749-934E-351FB98837B6}"/>
                </a:ext>
              </a:extLst>
            </p:cNvPr>
            <p:cNvSpPr/>
            <p:nvPr/>
          </p:nvSpPr>
          <p:spPr>
            <a:xfrm>
              <a:off x="5906759" y="92152"/>
              <a:ext cx="53469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solidFill>
                    <a:srgbClr val="0000FF"/>
                  </a:solidFill>
                </a:rPr>
                <a:t>DAPI</a:t>
              </a:r>
            </a:p>
          </p:txBody>
        </p: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D41A8782-09BF-5D4B-8947-A7CFA28A2F83}"/>
              </a:ext>
            </a:extLst>
          </p:cNvPr>
          <p:cNvSpPr txBox="1"/>
          <p:nvPr/>
        </p:nvSpPr>
        <p:spPr>
          <a:xfrm>
            <a:off x="1329045" y="824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5247DD8-D01F-AF4F-9969-83BE033B1CDA}"/>
              </a:ext>
            </a:extLst>
          </p:cNvPr>
          <p:cNvSpPr txBox="1"/>
          <p:nvPr/>
        </p:nvSpPr>
        <p:spPr>
          <a:xfrm>
            <a:off x="4484943" y="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944BA79-EBB5-114F-82D8-4F9F8E0B2140}"/>
              </a:ext>
            </a:extLst>
          </p:cNvPr>
          <p:cNvSpPr txBox="1"/>
          <p:nvPr/>
        </p:nvSpPr>
        <p:spPr>
          <a:xfrm>
            <a:off x="1329045" y="216297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9EDD582-F4E5-2746-9811-B5FD7BC8DA1B}"/>
              </a:ext>
            </a:extLst>
          </p:cNvPr>
          <p:cNvSpPr txBox="1"/>
          <p:nvPr/>
        </p:nvSpPr>
        <p:spPr>
          <a:xfrm>
            <a:off x="4484943" y="216297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6B138B6-469D-B84C-8346-33702284D88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6630759" y="4894236"/>
            <a:ext cx="914400" cy="9144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2E9809F-217E-5842-AF95-0F52044B2908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731571" y="4894236"/>
            <a:ext cx="914400" cy="9144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7553C67-3525-0649-BBE9-955598E23590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681155" y="4894236"/>
            <a:ext cx="914400" cy="9144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E52CC76-6FF3-8E40-A7D2-D84E902597EB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6630759" y="5851797"/>
            <a:ext cx="914400" cy="9144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CA7AEB05-90DD-5940-A505-E103D2D84CB6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732947" y="5851797"/>
            <a:ext cx="914400" cy="91440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FAEBD91D-CB30-8741-A96F-82C522C120BD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681877" y="5851797"/>
            <a:ext cx="914400" cy="914400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D24FEB40-5C9F-3A4F-8157-050B8B5A5102}"/>
              </a:ext>
            </a:extLst>
          </p:cNvPr>
          <p:cNvSpPr txBox="1"/>
          <p:nvPr/>
        </p:nvSpPr>
        <p:spPr>
          <a:xfrm>
            <a:off x="1329045" y="4407188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010365A-E0C1-2C4A-A4B6-EC04F5DF607A}"/>
              </a:ext>
            </a:extLst>
          </p:cNvPr>
          <p:cNvSpPr txBox="1"/>
          <p:nvPr/>
        </p:nvSpPr>
        <p:spPr>
          <a:xfrm>
            <a:off x="4697089" y="489423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CA50FA9-9A80-8E4E-8EFC-64BA22AC05FC}"/>
              </a:ext>
            </a:extLst>
          </p:cNvPr>
          <p:cNvSpPr txBox="1"/>
          <p:nvPr/>
        </p:nvSpPr>
        <p:spPr>
          <a:xfrm>
            <a:off x="4710135" y="5851797"/>
            <a:ext cx="838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Glis3KO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B343CAC-7FA7-304B-991B-ACE3F278EF93}"/>
              </a:ext>
            </a:extLst>
          </p:cNvPr>
          <p:cNvSpPr txBox="1"/>
          <p:nvPr/>
        </p:nvSpPr>
        <p:spPr>
          <a:xfrm>
            <a:off x="4916861" y="4640402"/>
            <a:ext cx="4267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FA00"/>
                </a:solidFill>
              </a:rPr>
              <a:t>NIS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29EE4BA0-FFFD-4941-AA71-7BC5EACFDF86}"/>
              </a:ext>
            </a:extLst>
          </p:cNvPr>
          <p:cNvSpPr/>
          <p:nvPr/>
        </p:nvSpPr>
        <p:spPr>
          <a:xfrm>
            <a:off x="6662447" y="4640402"/>
            <a:ext cx="84568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FA00"/>
                </a:solidFill>
              </a:rPr>
              <a:t>NIS</a:t>
            </a:r>
            <a:r>
              <a:rPr lang="en-US" sz="1400" dirty="0"/>
              <a:t>/</a:t>
            </a:r>
            <a:r>
              <a:rPr lang="en-US" sz="1400" dirty="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78CA2601-8E8B-6B47-8A86-A061D8D81263}"/>
              </a:ext>
            </a:extLst>
          </p:cNvPr>
          <p:cNvSpPr/>
          <p:nvPr/>
        </p:nvSpPr>
        <p:spPr>
          <a:xfrm>
            <a:off x="5834214" y="4640402"/>
            <a:ext cx="5346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831B3E9-63D5-3D43-AB04-D57AC7FEE32D}"/>
              </a:ext>
            </a:extLst>
          </p:cNvPr>
          <p:cNvSpPr txBox="1"/>
          <p:nvPr/>
        </p:nvSpPr>
        <p:spPr>
          <a:xfrm>
            <a:off x="4484943" y="4398721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CAE3B94-5C03-B54E-8633-6CAC88757B5F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500750" y="4894236"/>
            <a:ext cx="914400" cy="914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9881D8-17C7-5845-8C18-105B7476E792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1610376" y="4894236"/>
            <a:ext cx="914400" cy="914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9AFAE10-2E07-3A49-BBE8-6D153035FA3D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2555106" y="4894236"/>
            <a:ext cx="914400" cy="914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FC9A486-3D12-0549-8D2D-55CCDEEC6580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3500750" y="5851797"/>
            <a:ext cx="914400" cy="9144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9A2E98A-6112-0A4D-ACFC-0BE4217DD3EB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612285" y="5851797"/>
            <a:ext cx="914400" cy="9144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5DD982A-F654-1E44-B113-91EDE70258AC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2555106" y="5851797"/>
            <a:ext cx="914400" cy="914400"/>
          </a:xfrm>
          <a:prstGeom prst="rect">
            <a:avLst/>
          </a:prstGeom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0E4A8626-23CD-224B-B285-5C9719CDD12B}"/>
              </a:ext>
            </a:extLst>
          </p:cNvPr>
          <p:cNvSpPr txBox="1"/>
          <p:nvPr/>
        </p:nvSpPr>
        <p:spPr>
          <a:xfrm>
            <a:off x="1573772" y="486421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6626F50-29D2-DE4A-BA52-87B5A5F8076A}"/>
              </a:ext>
            </a:extLst>
          </p:cNvPr>
          <p:cNvSpPr txBox="1"/>
          <p:nvPr/>
        </p:nvSpPr>
        <p:spPr>
          <a:xfrm>
            <a:off x="1586818" y="5821779"/>
            <a:ext cx="838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Glis3KO2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B0E0F55-69A0-AA46-9C60-63D511AEC610}"/>
              </a:ext>
            </a:extLst>
          </p:cNvPr>
          <p:cNvSpPr txBox="1"/>
          <p:nvPr/>
        </p:nvSpPr>
        <p:spPr>
          <a:xfrm>
            <a:off x="1743831" y="4600574"/>
            <a:ext cx="5304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FA00"/>
                </a:solidFill>
              </a:rPr>
              <a:t>ZO-1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42232329-4A1D-954E-A6F9-9BD89BC8D5C7}"/>
              </a:ext>
            </a:extLst>
          </p:cNvPr>
          <p:cNvSpPr/>
          <p:nvPr/>
        </p:nvSpPr>
        <p:spPr>
          <a:xfrm>
            <a:off x="3156067" y="4600574"/>
            <a:ext cx="176079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srgbClr val="00FA00"/>
                </a:solidFill>
              </a:rPr>
              <a:t>ZO-1</a:t>
            </a:r>
            <a:r>
              <a:rPr lang="en-US" sz="1400" dirty="0"/>
              <a:t>/</a:t>
            </a:r>
            <a:r>
              <a:rPr lang="en-US" sz="1400" dirty="0">
                <a:solidFill>
                  <a:srgbClr val="FF0000"/>
                </a:solidFill>
              </a:rPr>
              <a:t>PECAM1</a:t>
            </a:r>
            <a:r>
              <a:rPr lang="en-US" sz="1400" dirty="0"/>
              <a:t>/</a:t>
            </a:r>
            <a:r>
              <a:rPr lang="en-US" sz="1400" dirty="0">
                <a:solidFill>
                  <a:srgbClr val="0000FF"/>
                </a:solidFill>
              </a:rPr>
              <a:t>DAPI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7EED44C-26F2-DC4B-B5C8-4FFB9F08BBB5}"/>
              </a:ext>
            </a:extLst>
          </p:cNvPr>
          <p:cNvSpPr txBox="1"/>
          <p:nvPr/>
        </p:nvSpPr>
        <p:spPr>
          <a:xfrm>
            <a:off x="2469396" y="4600574"/>
            <a:ext cx="8093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</a:rPr>
              <a:t>PECAM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FB2CC99-FAA7-EC44-A2CA-D38489B95559}"/>
              </a:ext>
            </a:extLst>
          </p:cNvPr>
          <p:cNvSpPr txBox="1"/>
          <p:nvPr/>
        </p:nvSpPr>
        <p:spPr>
          <a:xfrm>
            <a:off x="4655426" y="250076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3DD2237-F6A4-41E2-316A-643469191A7B}"/>
              </a:ext>
            </a:extLst>
          </p:cNvPr>
          <p:cNvSpPr/>
          <p:nvPr/>
        </p:nvSpPr>
        <p:spPr>
          <a:xfrm>
            <a:off x="7713630" y="6248671"/>
            <a:ext cx="123694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Batang" panose="02030600000101010101" pitchFamily="18" charset="-127"/>
              </a:rPr>
              <a:t>Supplementary</a:t>
            </a:r>
          </a:p>
          <a:p>
            <a:r>
              <a:rPr lang="en-US" sz="1200" b="1" dirty="0">
                <a:latin typeface="Times New Roman" panose="02020603050405020304" pitchFamily="18" charset="0"/>
                <a:ea typeface="Batang" panose="02030600000101010101" pitchFamily="18" charset="-127"/>
              </a:rPr>
              <a:t> Fig. 2</a:t>
            </a:r>
            <a:r>
              <a:rPr lang="en-US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 </a:t>
            </a:r>
            <a:endParaRPr lang="en-US" sz="1200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D4908960-162A-D478-8EA9-1047F22EE645}"/>
              </a:ext>
            </a:extLst>
          </p:cNvPr>
          <p:cNvCxnSpPr>
            <a:cxnSpLocks/>
          </p:cNvCxnSpPr>
          <p:nvPr/>
        </p:nvCxnSpPr>
        <p:spPr>
          <a:xfrm>
            <a:off x="7263487" y="1208613"/>
            <a:ext cx="2103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645ABF2E-EA8F-C832-F024-59A4A1D8E1A6}"/>
              </a:ext>
            </a:extLst>
          </p:cNvPr>
          <p:cNvCxnSpPr>
            <a:cxnSpLocks/>
          </p:cNvCxnSpPr>
          <p:nvPr/>
        </p:nvCxnSpPr>
        <p:spPr>
          <a:xfrm>
            <a:off x="3980991" y="5754661"/>
            <a:ext cx="41148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693BC99B-BE23-F11D-6B36-C57A5BAC2BDB}"/>
              </a:ext>
            </a:extLst>
          </p:cNvPr>
          <p:cNvCxnSpPr>
            <a:cxnSpLocks/>
          </p:cNvCxnSpPr>
          <p:nvPr/>
        </p:nvCxnSpPr>
        <p:spPr>
          <a:xfrm>
            <a:off x="3976426" y="6710336"/>
            <a:ext cx="41148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DDD263A7-DD87-8D1D-9488-BD33FE8D5FE7}"/>
              </a:ext>
            </a:extLst>
          </p:cNvPr>
          <p:cNvCxnSpPr>
            <a:cxnSpLocks/>
          </p:cNvCxnSpPr>
          <p:nvPr/>
        </p:nvCxnSpPr>
        <p:spPr>
          <a:xfrm>
            <a:off x="7048866" y="5754661"/>
            <a:ext cx="45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CEAF32AE-A57C-7D40-36BB-9BFC33446A42}"/>
              </a:ext>
            </a:extLst>
          </p:cNvPr>
          <p:cNvCxnSpPr>
            <a:cxnSpLocks/>
          </p:cNvCxnSpPr>
          <p:nvPr/>
        </p:nvCxnSpPr>
        <p:spPr>
          <a:xfrm>
            <a:off x="7056319" y="6698403"/>
            <a:ext cx="45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1484ED3C-6F0A-383E-E81D-331B84B97F72}"/>
              </a:ext>
            </a:extLst>
          </p:cNvPr>
          <p:cNvCxnSpPr>
            <a:cxnSpLocks/>
          </p:cNvCxnSpPr>
          <p:nvPr/>
        </p:nvCxnSpPr>
        <p:spPr>
          <a:xfrm>
            <a:off x="7284919" y="2180966"/>
            <a:ext cx="2103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4C7EB201-1081-5A22-808A-6415E956F507}"/>
              </a:ext>
            </a:extLst>
          </p:cNvPr>
          <p:cNvCxnSpPr>
            <a:cxnSpLocks/>
          </p:cNvCxnSpPr>
          <p:nvPr/>
        </p:nvCxnSpPr>
        <p:spPr>
          <a:xfrm>
            <a:off x="4156162" y="3388272"/>
            <a:ext cx="2103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BE5F9A60-9D22-A202-E68A-1907FBED0D7D}"/>
              </a:ext>
            </a:extLst>
          </p:cNvPr>
          <p:cNvCxnSpPr>
            <a:cxnSpLocks/>
          </p:cNvCxnSpPr>
          <p:nvPr/>
        </p:nvCxnSpPr>
        <p:spPr>
          <a:xfrm>
            <a:off x="4177594" y="4360625"/>
            <a:ext cx="2103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0E77B8CC-1E56-0CFC-2A29-F2D26A414FA0}"/>
              </a:ext>
            </a:extLst>
          </p:cNvPr>
          <p:cNvCxnSpPr>
            <a:cxnSpLocks/>
          </p:cNvCxnSpPr>
          <p:nvPr/>
        </p:nvCxnSpPr>
        <p:spPr>
          <a:xfrm>
            <a:off x="7242055" y="3388272"/>
            <a:ext cx="2103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CA564CF5-3F9E-5FF5-08DF-B17308FC53BA}"/>
              </a:ext>
            </a:extLst>
          </p:cNvPr>
          <p:cNvCxnSpPr>
            <a:cxnSpLocks/>
          </p:cNvCxnSpPr>
          <p:nvPr/>
        </p:nvCxnSpPr>
        <p:spPr>
          <a:xfrm>
            <a:off x="7263487" y="4360625"/>
            <a:ext cx="21031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222873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Chart 30">
            <a:extLst>
              <a:ext uri="{FF2B5EF4-FFF2-40B4-BE49-F238E27FC236}">
                <a16:creationId xmlns:a16="http://schemas.microsoft.com/office/drawing/2014/main" id="{DAF8312D-2666-FD1A-6975-4EB9B20564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6010610"/>
              </p:ext>
            </p:extLst>
          </p:nvPr>
        </p:nvGraphicFramePr>
        <p:xfrm>
          <a:off x="2421182" y="1817843"/>
          <a:ext cx="1940574" cy="14320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DD76384F-F116-1B34-1F64-D15B1B65E622}"/>
              </a:ext>
            </a:extLst>
          </p:cNvPr>
          <p:cNvSpPr txBox="1"/>
          <p:nvPr/>
        </p:nvSpPr>
        <p:spPr>
          <a:xfrm rot="16200000">
            <a:off x="1273158" y="2197660"/>
            <a:ext cx="18343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Relative expression </a:t>
            </a:r>
          </a:p>
          <a:p>
            <a:pPr algn="ctr"/>
            <a:r>
              <a:rPr lang="en-US" sz="1200" dirty="0"/>
              <a:t>(mRNA)</a:t>
            </a:r>
          </a:p>
        </p:txBody>
      </p:sp>
      <p:graphicFrame>
        <p:nvGraphicFramePr>
          <p:cNvPr id="34" name="Chart 33">
            <a:extLst>
              <a:ext uri="{FF2B5EF4-FFF2-40B4-BE49-F238E27FC236}">
                <a16:creationId xmlns:a16="http://schemas.microsoft.com/office/drawing/2014/main" id="{0AEDEC97-49C3-30A0-B63D-1FC135B958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654323"/>
              </p:ext>
            </p:extLst>
          </p:nvPr>
        </p:nvGraphicFramePr>
        <p:xfrm>
          <a:off x="4478974" y="1812527"/>
          <a:ext cx="2075026" cy="13333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F8E47775-B276-F6BA-E50E-5BD79D42324B}"/>
              </a:ext>
            </a:extLst>
          </p:cNvPr>
          <p:cNvSpPr/>
          <p:nvPr/>
        </p:nvSpPr>
        <p:spPr>
          <a:xfrm>
            <a:off x="6721146" y="6202011"/>
            <a:ext cx="16385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Batang" panose="02030600000101010101" pitchFamily="18" charset="-127"/>
              </a:rPr>
              <a:t>Supplementary Fig. 3</a:t>
            </a:r>
            <a:r>
              <a:rPr lang="en-US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821042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6">
            <a:extLst>
              <a:ext uri="{FF2B5EF4-FFF2-40B4-BE49-F238E27FC236}">
                <a16:creationId xmlns:a16="http://schemas.microsoft.com/office/drawing/2014/main" id="{434BBA2E-C31E-271A-4773-C7A585D7D6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8454889"/>
              </p:ext>
            </p:extLst>
          </p:nvPr>
        </p:nvGraphicFramePr>
        <p:xfrm>
          <a:off x="2304294" y="3967995"/>
          <a:ext cx="3757839" cy="1097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4259">
                  <a:extLst>
                    <a:ext uri="{9D8B030D-6E8A-4147-A177-3AD203B41FA5}">
                      <a16:colId xmlns:a16="http://schemas.microsoft.com/office/drawing/2014/main" val="1599526366"/>
                    </a:ext>
                  </a:extLst>
                </a:gridCol>
                <a:gridCol w="363450">
                  <a:extLst>
                    <a:ext uri="{9D8B030D-6E8A-4147-A177-3AD203B41FA5}">
                      <a16:colId xmlns:a16="http://schemas.microsoft.com/office/drawing/2014/main" val="2744921528"/>
                    </a:ext>
                  </a:extLst>
                </a:gridCol>
                <a:gridCol w="363450">
                  <a:extLst>
                    <a:ext uri="{9D8B030D-6E8A-4147-A177-3AD203B41FA5}">
                      <a16:colId xmlns:a16="http://schemas.microsoft.com/office/drawing/2014/main" val="417112413"/>
                    </a:ext>
                  </a:extLst>
                </a:gridCol>
                <a:gridCol w="373274">
                  <a:extLst>
                    <a:ext uri="{9D8B030D-6E8A-4147-A177-3AD203B41FA5}">
                      <a16:colId xmlns:a16="http://schemas.microsoft.com/office/drawing/2014/main" val="1882012626"/>
                    </a:ext>
                  </a:extLst>
                </a:gridCol>
                <a:gridCol w="343805">
                  <a:extLst>
                    <a:ext uri="{9D8B030D-6E8A-4147-A177-3AD203B41FA5}">
                      <a16:colId xmlns:a16="http://schemas.microsoft.com/office/drawing/2014/main" val="3737672810"/>
                    </a:ext>
                  </a:extLst>
                </a:gridCol>
                <a:gridCol w="392920">
                  <a:extLst>
                    <a:ext uri="{9D8B030D-6E8A-4147-A177-3AD203B41FA5}">
                      <a16:colId xmlns:a16="http://schemas.microsoft.com/office/drawing/2014/main" val="3791081676"/>
                    </a:ext>
                  </a:extLst>
                </a:gridCol>
                <a:gridCol w="373274">
                  <a:extLst>
                    <a:ext uri="{9D8B030D-6E8A-4147-A177-3AD203B41FA5}">
                      <a16:colId xmlns:a16="http://schemas.microsoft.com/office/drawing/2014/main" val="1610915190"/>
                    </a:ext>
                  </a:extLst>
                </a:gridCol>
                <a:gridCol w="373274">
                  <a:extLst>
                    <a:ext uri="{9D8B030D-6E8A-4147-A177-3AD203B41FA5}">
                      <a16:colId xmlns:a16="http://schemas.microsoft.com/office/drawing/2014/main" val="3338902739"/>
                    </a:ext>
                  </a:extLst>
                </a:gridCol>
                <a:gridCol w="370133">
                  <a:extLst>
                    <a:ext uri="{9D8B030D-6E8A-4147-A177-3AD203B41FA5}">
                      <a16:colId xmlns:a16="http://schemas.microsoft.com/office/drawing/2014/main" val="3757677923"/>
                    </a:ext>
                  </a:extLst>
                </a:gridCol>
              </a:tblGrid>
              <a:tr h="234496">
                <a:tc>
                  <a:txBody>
                    <a:bodyPr/>
                    <a:lstStyle/>
                    <a:p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GLISB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8437783"/>
                  </a:ext>
                </a:extLst>
              </a:tr>
              <a:tr h="234496">
                <a:tc>
                  <a:txBody>
                    <a:bodyPr/>
                    <a:lstStyle/>
                    <a:p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Glis3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9599353"/>
                  </a:ext>
                </a:extLst>
              </a:tr>
              <a:tr h="234496"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</a:rPr>
                        <a:t>TSH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+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1669060"/>
                  </a:ext>
                </a:extLst>
              </a:tr>
              <a:tr h="234496"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</a:rPr>
                        <a:t>ZSTK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10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>
                          <a:solidFill>
                            <a:schemeClr val="tx1"/>
                          </a:solidFill>
                        </a:rPr>
                        <a:t>50</a:t>
                      </a:r>
                      <a:endParaRPr lang="en-US" sz="12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</a:rPr>
                        <a:t>50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3267360"/>
                  </a:ext>
                </a:extLst>
              </a:tr>
            </a:tbl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3543E860-5DB5-EC1B-C393-E1B6FF9968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6058554"/>
              </p:ext>
            </p:extLst>
          </p:nvPr>
        </p:nvGraphicFramePr>
        <p:xfrm>
          <a:off x="2772834" y="1600200"/>
          <a:ext cx="3271310" cy="23232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F6098DC-94D7-D01C-C226-D4A546E680CD}"/>
              </a:ext>
            </a:extLst>
          </p:cNvPr>
          <p:cNvSpPr txBox="1"/>
          <p:nvPr/>
        </p:nvSpPr>
        <p:spPr>
          <a:xfrm>
            <a:off x="5963055" y="4764390"/>
            <a:ext cx="396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M</a:t>
            </a:r>
            <a:endParaRPr 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B63DD28-F4BF-3137-4B0C-410A6B63DA1B}"/>
              </a:ext>
            </a:extLst>
          </p:cNvPr>
          <p:cNvSpPr txBox="1"/>
          <p:nvPr/>
        </p:nvSpPr>
        <p:spPr>
          <a:xfrm rot="16200000">
            <a:off x="1415886" y="2751505"/>
            <a:ext cx="2053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Relative Luciferase activity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A576E51-7A2F-77DB-F144-82998A2144B4}"/>
              </a:ext>
            </a:extLst>
          </p:cNvPr>
          <p:cNvSpPr/>
          <p:nvPr/>
        </p:nvSpPr>
        <p:spPr>
          <a:xfrm>
            <a:off x="6721146" y="6202011"/>
            <a:ext cx="16385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Batang" panose="02030600000101010101" pitchFamily="18" charset="-127"/>
              </a:rPr>
              <a:t>Supplementary Fig. 4</a:t>
            </a:r>
            <a:r>
              <a:rPr lang="en-US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 </a:t>
            </a:r>
            <a:endParaRPr lang="en-US" sz="1200" dirty="0"/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2CD67705-4F80-6FB3-5D00-EFA84565E806}"/>
              </a:ext>
            </a:extLst>
          </p:cNvPr>
          <p:cNvCxnSpPr>
            <a:cxnSpLocks/>
          </p:cNvCxnSpPr>
          <p:nvPr/>
        </p:nvCxnSpPr>
        <p:spPr>
          <a:xfrm>
            <a:off x="4010377" y="2502694"/>
            <a:ext cx="3564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4CE1C94F-0BC0-74FF-C660-61AFE0F17AA1}"/>
              </a:ext>
            </a:extLst>
          </p:cNvPr>
          <p:cNvCxnSpPr>
            <a:cxnSpLocks/>
          </p:cNvCxnSpPr>
          <p:nvPr/>
        </p:nvCxnSpPr>
        <p:spPr>
          <a:xfrm>
            <a:off x="4366818" y="2499856"/>
            <a:ext cx="0" cy="1006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5EDD61FA-F798-A70F-AD4B-6C6A5BAB04E2}"/>
              </a:ext>
            </a:extLst>
          </p:cNvPr>
          <p:cNvCxnSpPr>
            <a:cxnSpLocks/>
          </p:cNvCxnSpPr>
          <p:nvPr/>
        </p:nvCxnSpPr>
        <p:spPr>
          <a:xfrm flipV="1">
            <a:off x="4010377" y="2499856"/>
            <a:ext cx="0" cy="4933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6F560726-823B-BA58-30DE-824918C6DDB5}"/>
              </a:ext>
            </a:extLst>
          </p:cNvPr>
          <p:cNvSpPr txBox="1"/>
          <p:nvPr/>
        </p:nvSpPr>
        <p:spPr>
          <a:xfrm>
            <a:off x="4058290" y="233471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4785495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3CED8C6-D288-3926-32D3-84AF83357C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9403" y="3246120"/>
            <a:ext cx="2755343" cy="2919491"/>
          </a:xfrm>
          <a:prstGeom prst="rect">
            <a:avLst/>
          </a:prstGeom>
        </p:spPr>
      </p:pic>
      <p:pic>
        <p:nvPicPr>
          <p:cNvPr id="2" name="Picture 1" descr="A picture containing green, dark, night, night sky&#10;&#10;Description automatically generated">
            <a:extLst>
              <a:ext uri="{FF2B5EF4-FFF2-40B4-BE49-F238E27FC236}">
                <a16:creationId xmlns:a16="http://schemas.microsoft.com/office/drawing/2014/main" id="{C4613F9D-3DDB-F0DC-E7E4-D436E702E5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835673" y="3834039"/>
            <a:ext cx="1097280" cy="1097280"/>
          </a:xfrm>
          <a:prstGeom prst="rect">
            <a:avLst/>
          </a:prstGeom>
        </p:spPr>
      </p:pic>
      <p:pic>
        <p:nvPicPr>
          <p:cNvPr id="5" name="Picture 4" descr="A picture containing dark, indoor, lit&#10;&#10;Description automatically generated">
            <a:extLst>
              <a:ext uri="{FF2B5EF4-FFF2-40B4-BE49-F238E27FC236}">
                <a16:creationId xmlns:a16="http://schemas.microsoft.com/office/drawing/2014/main" id="{A1913ED2-7322-437B-5DF0-37D98309962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94379" y="3834039"/>
            <a:ext cx="1097280" cy="1097280"/>
          </a:xfrm>
          <a:prstGeom prst="rect">
            <a:avLst/>
          </a:prstGeom>
        </p:spPr>
      </p:pic>
      <p:pic>
        <p:nvPicPr>
          <p:cNvPr id="6" name="Picture 5" descr="A picture containing lit, dark, ocean floor&#10;&#10;Description automatically generated">
            <a:extLst>
              <a:ext uri="{FF2B5EF4-FFF2-40B4-BE49-F238E27FC236}">
                <a16:creationId xmlns:a16="http://schemas.microsoft.com/office/drawing/2014/main" id="{70178CAC-982F-91E1-57AF-DD8FD946AFB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015415" y="3834039"/>
            <a:ext cx="1097280" cy="1097280"/>
          </a:xfrm>
          <a:prstGeom prst="rect">
            <a:avLst/>
          </a:prstGeom>
        </p:spPr>
      </p:pic>
      <p:pic>
        <p:nvPicPr>
          <p:cNvPr id="7" name="Picture 6" descr="A picture containing dark, night sky&#10;&#10;Description automatically generated">
            <a:extLst>
              <a:ext uri="{FF2B5EF4-FFF2-40B4-BE49-F238E27FC236}">
                <a16:creationId xmlns:a16="http://schemas.microsoft.com/office/drawing/2014/main" id="{CFC65A03-5915-B1AF-E974-3C11F0D86FD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694379" y="4968240"/>
            <a:ext cx="1097280" cy="1097280"/>
          </a:xfrm>
          <a:prstGeom prst="rect">
            <a:avLst/>
          </a:prstGeom>
        </p:spPr>
      </p:pic>
      <p:pic>
        <p:nvPicPr>
          <p:cNvPr id="8" name="Picture 7" descr="A picture containing green, indoor, dark, light&#10;&#10;Description automatically generated">
            <a:extLst>
              <a:ext uri="{FF2B5EF4-FFF2-40B4-BE49-F238E27FC236}">
                <a16:creationId xmlns:a16="http://schemas.microsoft.com/office/drawing/2014/main" id="{BDBF5451-ED23-8554-755C-B0B44A466B3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850047" y="4968240"/>
            <a:ext cx="1097280" cy="1097280"/>
          </a:xfrm>
          <a:prstGeom prst="rect">
            <a:avLst/>
          </a:prstGeom>
        </p:spPr>
      </p:pic>
      <p:pic>
        <p:nvPicPr>
          <p:cNvPr id="9" name="Picture 8" descr="A picture containing star, outdoor object&#10;&#10;Description automatically generated">
            <a:extLst>
              <a:ext uri="{FF2B5EF4-FFF2-40B4-BE49-F238E27FC236}">
                <a16:creationId xmlns:a16="http://schemas.microsoft.com/office/drawing/2014/main" id="{A7678F8B-47BF-BC98-4577-FACC81DB3A7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015415" y="4968240"/>
            <a:ext cx="1097280" cy="109728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82496E2-C5F0-5EA9-DEB7-AEC34631F221}"/>
              </a:ext>
            </a:extLst>
          </p:cNvPr>
          <p:cNvSpPr txBox="1"/>
          <p:nvPr/>
        </p:nvSpPr>
        <p:spPr>
          <a:xfrm>
            <a:off x="5046945" y="3506025"/>
            <a:ext cx="4635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IN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EF96937-5481-23AD-A49B-72D49F1956FE}"/>
              </a:ext>
            </a:extLst>
          </p:cNvPr>
          <p:cNvSpPr txBox="1"/>
          <p:nvPr/>
        </p:nvSpPr>
        <p:spPr>
          <a:xfrm>
            <a:off x="5989218" y="3506025"/>
            <a:ext cx="7720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rgbClr val="00D200"/>
                </a:solidFill>
              </a:rPr>
              <a:t>GC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EBEDCC3-2356-2326-972B-EBB2642D91C3}"/>
              </a:ext>
            </a:extLst>
          </p:cNvPr>
          <p:cNvSpPr txBox="1"/>
          <p:nvPr/>
        </p:nvSpPr>
        <p:spPr>
          <a:xfrm>
            <a:off x="6761231" y="3506025"/>
            <a:ext cx="1433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rgbClr val="FF0000"/>
                </a:solidFill>
              </a:rPr>
              <a:t>INS</a:t>
            </a:r>
            <a:r>
              <a:rPr lang="en-US" sz="1600" dirty="0"/>
              <a:t>/</a:t>
            </a:r>
            <a:r>
              <a:rPr lang="en-US" sz="1600" dirty="0">
                <a:solidFill>
                  <a:srgbClr val="00D200"/>
                </a:solidFill>
              </a:rPr>
              <a:t>GCG</a:t>
            </a:r>
            <a:r>
              <a:rPr lang="en-US" sz="1600" dirty="0"/>
              <a:t>/</a:t>
            </a:r>
            <a:r>
              <a:rPr lang="en-US" sz="1600" dirty="0">
                <a:solidFill>
                  <a:srgbClr val="0070C0"/>
                </a:solidFill>
              </a:rPr>
              <a:t>DAP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290E3F5-7983-B908-EA1A-2D0A5D7D1C1B}"/>
              </a:ext>
            </a:extLst>
          </p:cNvPr>
          <p:cNvSpPr txBox="1"/>
          <p:nvPr/>
        </p:nvSpPr>
        <p:spPr>
          <a:xfrm>
            <a:off x="4073846" y="4149205"/>
            <a:ext cx="4667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W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4D3B0C9-3856-2B7E-83F9-4BA6B11BA77B}"/>
              </a:ext>
            </a:extLst>
          </p:cNvPr>
          <p:cNvSpPr txBox="1"/>
          <p:nvPr/>
        </p:nvSpPr>
        <p:spPr>
          <a:xfrm>
            <a:off x="4073846" y="5252561"/>
            <a:ext cx="5275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KO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6B3F4DF-5B9A-ED29-6CA5-88C445DE7DCE}"/>
              </a:ext>
            </a:extLst>
          </p:cNvPr>
          <p:cNvSpPr/>
          <p:nvPr/>
        </p:nvSpPr>
        <p:spPr>
          <a:xfrm>
            <a:off x="6941222" y="6483864"/>
            <a:ext cx="16385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Batang" panose="02030600000101010101" pitchFamily="18" charset="-127"/>
              </a:rPr>
              <a:t>Supplementary Fig. 5</a:t>
            </a:r>
            <a:r>
              <a:rPr lang="en-US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 </a:t>
            </a:r>
            <a:endParaRPr lang="en-US" sz="1200" dirty="0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11202BD7-995D-6428-11F7-D6987CD8EB34}"/>
              </a:ext>
            </a:extLst>
          </p:cNvPr>
          <p:cNvCxnSpPr>
            <a:cxnSpLocks/>
          </p:cNvCxnSpPr>
          <p:nvPr/>
        </p:nvCxnSpPr>
        <p:spPr>
          <a:xfrm>
            <a:off x="7802635" y="4868524"/>
            <a:ext cx="27432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856F624-7121-3751-2283-822CFE65336C}"/>
              </a:ext>
            </a:extLst>
          </p:cNvPr>
          <p:cNvCxnSpPr>
            <a:cxnSpLocks/>
          </p:cNvCxnSpPr>
          <p:nvPr/>
        </p:nvCxnSpPr>
        <p:spPr>
          <a:xfrm>
            <a:off x="7788615" y="5985330"/>
            <a:ext cx="27432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9B34014-01F2-4505-BA4B-41BA78C0FE4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9418012"/>
              </p:ext>
            </p:extLst>
          </p:nvPr>
        </p:nvGraphicFramePr>
        <p:xfrm>
          <a:off x="769483" y="655403"/>
          <a:ext cx="1703814" cy="2128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01116B22-0DA9-7650-49A1-67D1F9984D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12169"/>
              </p:ext>
            </p:extLst>
          </p:nvPr>
        </p:nvGraphicFramePr>
        <p:xfrm>
          <a:off x="2532549" y="655403"/>
          <a:ext cx="1703813" cy="22083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pSp>
        <p:nvGrpSpPr>
          <p:cNvPr id="17" name="Group 16">
            <a:extLst>
              <a:ext uri="{FF2B5EF4-FFF2-40B4-BE49-F238E27FC236}">
                <a16:creationId xmlns:a16="http://schemas.microsoft.com/office/drawing/2014/main" id="{DBA79D04-C592-7097-08D2-6C3BA512D1BF}"/>
              </a:ext>
            </a:extLst>
          </p:cNvPr>
          <p:cNvGrpSpPr/>
          <p:nvPr/>
        </p:nvGrpSpPr>
        <p:grpSpPr>
          <a:xfrm>
            <a:off x="1345761" y="1215872"/>
            <a:ext cx="484511" cy="387984"/>
            <a:chOff x="1725433" y="1184744"/>
            <a:chExt cx="659041" cy="658124"/>
          </a:xfrm>
        </p:grpSpPr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8DCF5ED0-8839-1DD1-146F-87CBC98151EE}"/>
                </a:ext>
              </a:extLst>
            </p:cNvPr>
            <p:cNvCxnSpPr>
              <a:cxnSpLocks/>
            </p:cNvCxnSpPr>
            <p:nvPr/>
          </p:nvCxnSpPr>
          <p:spPr>
            <a:xfrm>
              <a:off x="1725433" y="1184744"/>
              <a:ext cx="6590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DECCFF1D-CB1A-A202-441E-DAC5F371576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25433" y="1184744"/>
              <a:ext cx="0" cy="1524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1AFCFFDF-C6E7-4D85-6A28-43D27A19D6F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84474" y="1184744"/>
              <a:ext cx="0" cy="658124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9B5AE561-BDFF-6803-A0A2-0E706F891C92}"/>
              </a:ext>
            </a:extLst>
          </p:cNvPr>
          <p:cNvSpPr txBox="1"/>
          <p:nvPr/>
        </p:nvSpPr>
        <p:spPr>
          <a:xfrm>
            <a:off x="1456545" y="93927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S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4E5FB49-D2B5-BBE1-C4A5-C678891A8C3A}"/>
              </a:ext>
            </a:extLst>
          </p:cNvPr>
          <p:cNvGrpSpPr/>
          <p:nvPr/>
        </p:nvGrpSpPr>
        <p:grpSpPr>
          <a:xfrm>
            <a:off x="3105627" y="1181224"/>
            <a:ext cx="489347" cy="461665"/>
            <a:chOff x="1725433" y="1184744"/>
            <a:chExt cx="659041" cy="346804"/>
          </a:xfrm>
        </p:grpSpPr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32976D56-24B9-34AB-1FC6-D81AFB824483}"/>
                </a:ext>
              </a:extLst>
            </p:cNvPr>
            <p:cNvCxnSpPr>
              <a:cxnSpLocks/>
            </p:cNvCxnSpPr>
            <p:nvPr/>
          </p:nvCxnSpPr>
          <p:spPr>
            <a:xfrm>
              <a:off x="1725433" y="1184744"/>
              <a:ext cx="6590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FF380E4F-BEAE-FA88-2237-2E8D4EC00BC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25433" y="1184744"/>
              <a:ext cx="0" cy="1524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6FB7D1C9-4E52-DCBD-1327-42C76CE41D0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84474" y="1184744"/>
              <a:ext cx="0" cy="346804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87528C0E-AEBE-05E5-C3D4-551E9AE70F81}"/>
              </a:ext>
            </a:extLst>
          </p:cNvPr>
          <p:cNvSpPr txBox="1"/>
          <p:nvPr/>
        </p:nvSpPr>
        <p:spPr>
          <a:xfrm>
            <a:off x="3216411" y="938873"/>
            <a:ext cx="437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S</a:t>
            </a:r>
          </a:p>
        </p:txBody>
      </p:sp>
      <p:graphicFrame>
        <p:nvGraphicFramePr>
          <p:cNvPr id="30" name="Chart 29">
            <a:extLst>
              <a:ext uri="{FF2B5EF4-FFF2-40B4-BE49-F238E27FC236}">
                <a16:creationId xmlns:a16="http://schemas.microsoft.com/office/drawing/2014/main" id="{354B3E01-412F-F4F7-7EC4-B0C77F8CE9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5093759"/>
              </p:ext>
            </p:extLst>
          </p:nvPr>
        </p:nvGraphicFramePr>
        <p:xfrm>
          <a:off x="4446880" y="655403"/>
          <a:ext cx="1703813" cy="2120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pSp>
        <p:nvGrpSpPr>
          <p:cNvPr id="31" name="Group 30">
            <a:extLst>
              <a:ext uri="{FF2B5EF4-FFF2-40B4-BE49-F238E27FC236}">
                <a16:creationId xmlns:a16="http://schemas.microsoft.com/office/drawing/2014/main" id="{61917297-2F5D-A5F5-DC95-778A7D000B75}"/>
              </a:ext>
            </a:extLst>
          </p:cNvPr>
          <p:cNvGrpSpPr/>
          <p:nvPr/>
        </p:nvGrpSpPr>
        <p:grpSpPr>
          <a:xfrm>
            <a:off x="5026842" y="1256939"/>
            <a:ext cx="483691" cy="379937"/>
            <a:chOff x="1725433" y="1184744"/>
            <a:chExt cx="659041" cy="441240"/>
          </a:xfrm>
        </p:grpSpPr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EB86C975-8DE5-1068-2137-3FB2BE631530}"/>
                </a:ext>
              </a:extLst>
            </p:cNvPr>
            <p:cNvCxnSpPr>
              <a:cxnSpLocks/>
            </p:cNvCxnSpPr>
            <p:nvPr/>
          </p:nvCxnSpPr>
          <p:spPr>
            <a:xfrm>
              <a:off x="1725433" y="1184744"/>
              <a:ext cx="6590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614D0B33-2BC7-D79A-D6D9-5FB3BF9680E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25433" y="1184744"/>
              <a:ext cx="0" cy="1524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8E627F0A-BB0E-E710-9987-48909714EE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84474" y="1184744"/>
              <a:ext cx="0" cy="44124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51D2E077-AD95-F09B-7363-A358BCA14D17}"/>
              </a:ext>
            </a:extLst>
          </p:cNvPr>
          <p:cNvSpPr txBox="1"/>
          <p:nvPr/>
        </p:nvSpPr>
        <p:spPr>
          <a:xfrm>
            <a:off x="5073174" y="938873"/>
            <a:ext cx="626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S</a:t>
            </a:r>
          </a:p>
        </p:txBody>
      </p:sp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AC03409C-B273-4675-22FA-CD20264736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3652980"/>
              </p:ext>
            </p:extLst>
          </p:nvPr>
        </p:nvGraphicFramePr>
        <p:xfrm>
          <a:off x="6283414" y="655403"/>
          <a:ext cx="1514825" cy="2120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pSp>
        <p:nvGrpSpPr>
          <p:cNvPr id="38" name="Group 37">
            <a:extLst>
              <a:ext uri="{FF2B5EF4-FFF2-40B4-BE49-F238E27FC236}">
                <a16:creationId xmlns:a16="http://schemas.microsoft.com/office/drawing/2014/main" id="{839E30F7-9491-E751-7565-3B0E228A9E44}"/>
              </a:ext>
            </a:extLst>
          </p:cNvPr>
          <p:cNvGrpSpPr/>
          <p:nvPr/>
        </p:nvGrpSpPr>
        <p:grpSpPr>
          <a:xfrm>
            <a:off x="6822468" y="1215872"/>
            <a:ext cx="391878" cy="387984"/>
            <a:chOff x="1725433" y="1184744"/>
            <a:chExt cx="659041" cy="321821"/>
          </a:xfrm>
        </p:grpSpPr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193C2958-CC1A-D11C-0EA3-F0AEBCA9E519}"/>
                </a:ext>
              </a:extLst>
            </p:cNvPr>
            <p:cNvCxnSpPr>
              <a:cxnSpLocks/>
            </p:cNvCxnSpPr>
            <p:nvPr/>
          </p:nvCxnSpPr>
          <p:spPr>
            <a:xfrm>
              <a:off x="1725433" y="1184744"/>
              <a:ext cx="6590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CE2CA6D4-A32D-BCCE-5FBD-B6FF2D91D26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25433" y="1184744"/>
              <a:ext cx="0" cy="15240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309E6E32-2EA4-F5A6-1718-361EDBB9A4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84474" y="1184744"/>
              <a:ext cx="0" cy="321821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6CFFCA5F-00EB-6617-4A34-5E01D9D59E7E}"/>
              </a:ext>
            </a:extLst>
          </p:cNvPr>
          <p:cNvSpPr txBox="1"/>
          <p:nvPr/>
        </p:nvSpPr>
        <p:spPr>
          <a:xfrm>
            <a:off x="6852020" y="966400"/>
            <a:ext cx="389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C56D3CA-A811-A45B-6A56-E0A05CA27C34}"/>
              </a:ext>
            </a:extLst>
          </p:cNvPr>
          <p:cNvSpPr txBox="1"/>
          <p:nvPr/>
        </p:nvSpPr>
        <p:spPr>
          <a:xfrm rot="16200000">
            <a:off x="-265353" y="1449967"/>
            <a:ext cx="15901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ive expressio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2B0E6B6-AFEE-C7EE-BEED-3D6D0E14E171}"/>
              </a:ext>
            </a:extLst>
          </p:cNvPr>
          <p:cNvSpPr txBox="1"/>
          <p:nvPr/>
        </p:nvSpPr>
        <p:spPr>
          <a:xfrm>
            <a:off x="222381" y="4394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96F48E1-AC6D-5EA0-81A0-B7F65408C104}"/>
              </a:ext>
            </a:extLst>
          </p:cNvPr>
          <p:cNvSpPr txBox="1"/>
          <p:nvPr/>
        </p:nvSpPr>
        <p:spPr>
          <a:xfrm>
            <a:off x="207039" y="32443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C631224-04E8-DE2E-0C06-86D9B1ABE022}"/>
              </a:ext>
            </a:extLst>
          </p:cNvPr>
          <p:cNvSpPr txBox="1"/>
          <p:nvPr/>
        </p:nvSpPr>
        <p:spPr>
          <a:xfrm>
            <a:off x="4084725" y="32443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9313645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Group 75">
            <a:extLst>
              <a:ext uri="{FF2B5EF4-FFF2-40B4-BE49-F238E27FC236}">
                <a16:creationId xmlns:a16="http://schemas.microsoft.com/office/drawing/2014/main" id="{F1C187B0-40E4-CE4C-BA33-6F8BA7C1E2CA}"/>
              </a:ext>
            </a:extLst>
          </p:cNvPr>
          <p:cNvGrpSpPr/>
          <p:nvPr/>
        </p:nvGrpSpPr>
        <p:grpSpPr>
          <a:xfrm>
            <a:off x="7004012" y="5139711"/>
            <a:ext cx="932156" cy="594358"/>
            <a:chOff x="5925276" y="876647"/>
            <a:chExt cx="932156" cy="584390"/>
          </a:xfrm>
        </p:grpSpPr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22D70948-51A6-4A48-B81B-99973E82CEBA}"/>
                </a:ext>
              </a:extLst>
            </p:cNvPr>
            <p:cNvSpPr/>
            <p:nvPr/>
          </p:nvSpPr>
          <p:spPr>
            <a:xfrm>
              <a:off x="5925276" y="963660"/>
              <a:ext cx="137160" cy="13716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77"/>
              <a:endParaRPr lang="en-US" sz="1200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82DA2736-E916-A345-820E-E5415468961D}"/>
                </a:ext>
              </a:extLst>
            </p:cNvPr>
            <p:cNvSpPr/>
            <p:nvPr/>
          </p:nvSpPr>
          <p:spPr>
            <a:xfrm>
              <a:off x="5925276" y="1271049"/>
              <a:ext cx="137160" cy="137160"/>
            </a:xfrm>
            <a:prstGeom prst="rect">
              <a:avLst/>
            </a:prstGeom>
            <a:solidFill>
              <a:srgbClr val="EE7D3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77"/>
              <a:endParaRPr lang="en-US" sz="1200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699455B-8BEC-DB46-AB6C-E4E6CF2AF4F8}"/>
                </a:ext>
              </a:extLst>
            </p:cNvPr>
            <p:cNvSpPr txBox="1"/>
            <p:nvPr/>
          </p:nvSpPr>
          <p:spPr>
            <a:xfrm>
              <a:off x="6129462" y="876647"/>
              <a:ext cx="5504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377"/>
              <a:r>
                <a:rPr lang="en-US" sz="1200" dirty="0">
                  <a:solidFill>
                    <a:prstClr val="black"/>
                  </a:solidFill>
                  <a:latin typeface="Calibri" panose="020F0502020204030204"/>
                </a:rPr>
                <a:t>WT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8E5B4F4E-5146-FB47-825A-A4B9A1E10658}"/>
                </a:ext>
              </a:extLst>
            </p:cNvPr>
            <p:cNvSpPr txBox="1"/>
            <p:nvPr/>
          </p:nvSpPr>
          <p:spPr>
            <a:xfrm>
              <a:off x="6129463" y="1184038"/>
              <a:ext cx="7279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377"/>
              <a:r>
                <a:rPr lang="en-US" sz="1200" dirty="0">
                  <a:solidFill>
                    <a:prstClr val="black"/>
                  </a:solidFill>
                  <a:latin typeface="Calibri" panose="020F0502020204030204"/>
                </a:rPr>
                <a:t>CKO</a:t>
              </a:r>
            </a:p>
          </p:txBody>
        </p:sp>
      </p:grpSp>
      <p:graphicFrame>
        <p:nvGraphicFramePr>
          <p:cNvPr id="81" name="Chart 80">
            <a:extLst>
              <a:ext uri="{FF2B5EF4-FFF2-40B4-BE49-F238E27FC236}">
                <a16:creationId xmlns:a16="http://schemas.microsoft.com/office/drawing/2014/main" id="{C24C6789-E685-D145-B572-104EB0BB4C4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2965032"/>
              </p:ext>
            </p:extLst>
          </p:nvPr>
        </p:nvGraphicFramePr>
        <p:xfrm>
          <a:off x="5143659" y="393491"/>
          <a:ext cx="13716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2" name="Chart 81">
            <a:extLst>
              <a:ext uri="{FF2B5EF4-FFF2-40B4-BE49-F238E27FC236}">
                <a16:creationId xmlns:a16="http://schemas.microsoft.com/office/drawing/2014/main" id="{F7DE85CF-29FB-954E-B561-F6FBED7436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1345194"/>
              </p:ext>
            </p:extLst>
          </p:nvPr>
        </p:nvGraphicFramePr>
        <p:xfrm>
          <a:off x="6725700" y="402783"/>
          <a:ext cx="13716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1C11BBAC-8EEB-EB46-A6F2-954DCA31578D}"/>
              </a:ext>
            </a:extLst>
          </p:cNvPr>
          <p:cNvCxnSpPr>
            <a:cxnSpLocks/>
          </p:cNvCxnSpPr>
          <p:nvPr/>
        </p:nvCxnSpPr>
        <p:spPr>
          <a:xfrm>
            <a:off x="7219235" y="1060400"/>
            <a:ext cx="5367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61C8295A-D0E0-A940-8213-E9A7D51F5646}"/>
              </a:ext>
            </a:extLst>
          </p:cNvPr>
          <p:cNvCxnSpPr>
            <a:cxnSpLocks/>
          </p:cNvCxnSpPr>
          <p:nvPr/>
        </p:nvCxnSpPr>
        <p:spPr>
          <a:xfrm flipH="1" flipV="1">
            <a:off x="7756002" y="1055896"/>
            <a:ext cx="1" cy="432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1276D8D2-C6A7-9D4F-A7EB-0254D71D3CE2}"/>
              </a:ext>
            </a:extLst>
          </p:cNvPr>
          <p:cNvCxnSpPr>
            <a:cxnSpLocks/>
          </p:cNvCxnSpPr>
          <p:nvPr/>
        </p:nvCxnSpPr>
        <p:spPr>
          <a:xfrm flipV="1">
            <a:off x="7219235" y="1055936"/>
            <a:ext cx="0" cy="7738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F87D986D-42BB-4843-B3E3-D88C9BCF1CDA}"/>
              </a:ext>
            </a:extLst>
          </p:cNvPr>
          <p:cNvSpPr txBox="1"/>
          <p:nvPr/>
        </p:nvSpPr>
        <p:spPr>
          <a:xfrm>
            <a:off x="7322548" y="85086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*</a:t>
            </a: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C34D00F3-D54B-EA46-8802-47E76CD5B122}"/>
              </a:ext>
            </a:extLst>
          </p:cNvPr>
          <p:cNvCxnSpPr>
            <a:cxnSpLocks/>
          </p:cNvCxnSpPr>
          <p:nvPr/>
        </p:nvCxnSpPr>
        <p:spPr>
          <a:xfrm flipV="1">
            <a:off x="7902741" y="961216"/>
            <a:ext cx="0" cy="7652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B1AFE72E-AE2A-944A-AB20-BED72DD49647}"/>
              </a:ext>
            </a:extLst>
          </p:cNvPr>
          <p:cNvSpPr txBox="1"/>
          <p:nvPr/>
        </p:nvSpPr>
        <p:spPr>
          <a:xfrm>
            <a:off x="7681057" y="788666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*</a:t>
            </a: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DE1D73A3-A50E-754D-8FCD-E2E2322B6E0C}"/>
              </a:ext>
            </a:extLst>
          </p:cNvPr>
          <p:cNvCxnSpPr>
            <a:cxnSpLocks/>
          </p:cNvCxnSpPr>
          <p:nvPr/>
        </p:nvCxnSpPr>
        <p:spPr>
          <a:xfrm flipV="1">
            <a:off x="7754049" y="961216"/>
            <a:ext cx="1" cy="790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2D2AE7F1-62D5-6743-A352-16507D9154D9}"/>
              </a:ext>
            </a:extLst>
          </p:cNvPr>
          <p:cNvCxnSpPr>
            <a:cxnSpLocks/>
          </p:cNvCxnSpPr>
          <p:nvPr/>
        </p:nvCxnSpPr>
        <p:spPr>
          <a:xfrm flipH="1">
            <a:off x="7754050" y="961216"/>
            <a:ext cx="1457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B9BC5603-BDEF-094C-86B7-A45F7B45E820}"/>
              </a:ext>
            </a:extLst>
          </p:cNvPr>
          <p:cNvCxnSpPr>
            <a:cxnSpLocks/>
          </p:cNvCxnSpPr>
          <p:nvPr/>
        </p:nvCxnSpPr>
        <p:spPr>
          <a:xfrm>
            <a:off x="6151208" y="831499"/>
            <a:ext cx="1757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989AAF10-AA7C-DE43-8B59-45D7BE9C75C0}"/>
              </a:ext>
            </a:extLst>
          </p:cNvPr>
          <p:cNvCxnSpPr>
            <a:cxnSpLocks/>
          </p:cNvCxnSpPr>
          <p:nvPr/>
        </p:nvCxnSpPr>
        <p:spPr>
          <a:xfrm flipV="1">
            <a:off x="6151208" y="835457"/>
            <a:ext cx="0" cy="308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1FB907C3-85DF-FF4A-AB7C-D1E0AD791989}"/>
              </a:ext>
            </a:extLst>
          </p:cNvPr>
          <p:cNvCxnSpPr>
            <a:cxnSpLocks/>
          </p:cNvCxnSpPr>
          <p:nvPr/>
        </p:nvCxnSpPr>
        <p:spPr>
          <a:xfrm flipV="1">
            <a:off x="5578778" y="1434945"/>
            <a:ext cx="0" cy="1023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74D12087-A47A-314B-8B97-CEC75FC1E886}"/>
              </a:ext>
            </a:extLst>
          </p:cNvPr>
          <p:cNvSpPr txBox="1"/>
          <p:nvPr/>
        </p:nvSpPr>
        <p:spPr>
          <a:xfrm>
            <a:off x="5556055" y="1251737"/>
            <a:ext cx="162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28ADA45F-C85B-B54C-A02B-E1AD9F689652}"/>
              </a:ext>
            </a:extLst>
          </p:cNvPr>
          <p:cNvCxnSpPr>
            <a:cxnSpLocks/>
          </p:cNvCxnSpPr>
          <p:nvPr/>
        </p:nvCxnSpPr>
        <p:spPr>
          <a:xfrm>
            <a:off x="5585374" y="1433082"/>
            <a:ext cx="1589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0B98BF30-ED71-D640-B2B1-6041496B9519}"/>
              </a:ext>
            </a:extLst>
          </p:cNvPr>
          <p:cNvCxnSpPr>
            <a:cxnSpLocks/>
          </p:cNvCxnSpPr>
          <p:nvPr/>
        </p:nvCxnSpPr>
        <p:spPr>
          <a:xfrm flipH="1" flipV="1">
            <a:off x="6147198" y="789775"/>
            <a:ext cx="1" cy="308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912CAEB8-70E5-524D-8E2A-E73C145C137B}"/>
              </a:ext>
            </a:extLst>
          </p:cNvPr>
          <p:cNvCxnSpPr>
            <a:cxnSpLocks/>
          </p:cNvCxnSpPr>
          <p:nvPr/>
        </p:nvCxnSpPr>
        <p:spPr>
          <a:xfrm flipV="1">
            <a:off x="5744332" y="1434945"/>
            <a:ext cx="863" cy="3196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08A36165-AF8C-AC46-AF46-726C14708EA5}"/>
              </a:ext>
            </a:extLst>
          </p:cNvPr>
          <p:cNvSpPr txBox="1"/>
          <p:nvPr/>
        </p:nvSpPr>
        <p:spPr>
          <a:xfrm>
            <a:off x="5677903" y="611479"/>
            <a:ext cx="3936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***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B4832CAB-6501-1B45-88DF-5B463732CBF8}"/>
              </a:ext>
            </a:extLst>
          </p:cNvPr>
          <p:cNvCxnSpPr>
            <a:cxnSpLocks/>
          </p:cNvCxnSpPr>
          <p:nvPr/>
        </p:nvCxnSpPr>
        <p:spPr>
          <a:xfrm flipV="1">
            <a:off x="6326981" y="835458"/>
            <a:ext cx="0" cy="9668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1F07A63E-BC45-8D4B-8BC0-2924B6CFC23D}"/>
              </a:ext>
            </a:extLst>
          </p:cNvPr>
          <p:cNvSpPr txBox="1"/>
          <p:nvPr/>
        </p:nvSpPr>
        <p:spPr>
          <a:xfrm>
            <a:off x="6076629" y="646289"/>
            <a:ext cx="4232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***</a:t>
            </a: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A33BC91F-8F0F-FE49-9ED2-D51D9EF1EAB6}"/>
              </a:ext>
            </a:extLst>
          </p:cNvPr>
          <p:cNvCxnSpPr>
            <a:cxnSpLocks/>
          </p:cNvCxnSpPr>
          <p:nvPr/>
        </p:nvCxnSpPr>
        <p:spPr>
          <a:xfrm flipV="1">
            <a:off x="5578778" y="791912"/>
            <a:ext cx="6597" cy="5757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9E089A29-75B3-344D-A4B7-BEC02BBC61F1}"/>
              </a:ext>
            </a:extLst>
          </p:cNvPr>
          <p:cNvCxnSpPr>
            <a:cxnSpLocks/>
          </p:cNvCxnSpPr>
          <p:nvPr/>
        </p:nvCxnSpPr>
        <p:spPr>
          <a:xfrm flipH="1">
            <a:off x="5585374" y="789775"/>
            <a:ext cx="5586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7" name="Chart 106">
            <a:extLst>
              <a:ext uri="{FF2B5EF4-FFF2-40B4-BE49-F238E27FC236}">
                <a16:creationId xmlns:a16="http://schemas.microsoft.com/office/drawing/2014/main" id="{0F8A12D0-79C5-9A4B-B734-3169D23A76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174960"/>
              </p:ext>
            </p:extLst>
          </p:nvPr>
        </p:nvGraphicFramePr>
        <p:xfrm>
          <a:off x="1516150" y="344113"/>
          <a:ext cx="1436203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8" name="Chart 107">
            <a:extLst>
              <a:ext uri="{FF2B5EF4-FFF2-40B4-BE49-F238E27FC236}">
                <a16:creationId xmlns:a16="http://schemas.microsoft.com/office/drawing/2014/main" id="{5BB62CB5-A549-7D41-BCD8-456139CAFF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515980"/>
              </p:ext>
            </p:extLst>
          </p:nvPr>
        </p:nvGraphicFramePr>
        <p:xfrm>
          <a:off x="3396033" y="360801"/>
          <a:ext cx="13716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109" name="Group 108">
            <a:extLst>
              <a:ext uri="{FF2B5EF4-FFF2-40B4-BE49-F238E27FC236}">
                <a16:creationId xmlns:a16="http://schemas.microsoft.com/office/drawing/2014/main" id="{404BD676-6888-894D-8666-74DEFE97E52F}"/>
              </a:ext>
            </a:extLst>
          </p:cNvPr>
          <p:cNvGrpSpPr/>
          <p:nvPr/>
        </p:nvGrpSpPr>
        <p:grpSpPr>
          <a:xfrm>
            <a:off x="2001438" y="816178"/>
            <a:ext cx="537273" cy="874621"/>
            <a:chOff x="236117" y="672878"/>
            <a:chExt cx="759843" cy="1348181"/>
          </a:xfrm>
        </p:grpSpPr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69A47031-D2EE-6645-AC92-72DDB31198DB}"/>
                </a:ext>
              </a:extLst>
            </p:cNvPr>
            <p:cNvCxnSpPr>
              <a:cxnSpLocks/>
            </p:cNvCxnSpPr>
            <p:nvPr/>
          </p:nvCxnSpPr>
          <p:spPr>
            <a:xfrm>
              <a:off x="236117" y="759755"/>
              <a:ext cx="759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333129E0-18AF-364A-BF16-637FDDA0426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95959" y="754951"/>
              <a:ext cx="1" cy="88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7E4525FA-A7C9-9A44-AF9F-E29A198EA07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6117" y="754951"/>
              <a:ext cx="0" cy="12661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BDA6F979-BF68-2146-8769-1AD7ED4D9AE4}"/>
                </a:ext>
              </a:extLst>
            </p:cNvPr>
            <p:cNvSpPr txBox="1"/>
            <p:nvPr/>
          </p:nvSpPr>
          <p:spPr>
            <a:xfrm>
              <a:off x="411916" y="672878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**</a:t>
              </a:r>
            </a:p>
          </p:txBody>
        </p: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24BCE652-5B1D-BB4A-A6F6-ECC78F673F70}"/>
              </a:ext>
            </a:extLst>
          </p:cNvPr>
          <p:cNvGrpSpPr/>
          <p:nvPr/>
        </p:nvGrpSpPr>
        <p:grpSpPr>
          <a:xfrm>
            <a:off x="2131895" y="631283"/>
            <a:ext cx="607945" cy="662035"/>
            <a:chOff x="236117" y="531213"/>
            <a:chExt cx="759843" cy="936216"/>
          </a:xfrm>
        </p:grpSpPr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F7907F6C-8D65-AF43-A3CF-02F49E465A48}"/>
                </a:ext>
              </a:extLst>
            </p:cNvPr>
            <p:cNvCxnSpPr>
              <a:cxnSpLocks/>
            </p:cNvCxnSpPr>
            <p:nvPr/>
          </p:nvCxnSpPr>
          <p:spPr>
            <a:xfrm>
              <a:off x="236117" y="759755"/>
              <a:ext cx="759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5C751416-B41E-0542-9D95-A37093BB887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95959" y="754951"/>
              <a:ext cx="1" cy="88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5C7E5F4A-8584-B647-832E-308C280E4D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6117" y="754951"/>
              <a:ext cx="0" cy="71247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14BB1EAB-23C8-1242-B233-007F235DCC31}"/>
                </a:ext>
              </a:extLst>
            </p:cNvPr>
            <p:cNvSpPr txBox="1"/>
            <p:nvPr/>
          </p:nvSpPr>
          <p:spPr>
            <a:xfrm>
              <a:off x="489169" y="531213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**</a:t>
              </a:r>
            </a:p>
          </p:txBody>
        </p:sp>
      </p:grpSp>
      <p:grpSp>
        <p:nvGrpSpPr>
          <p:cNvPr id="132" name="Group 131">
            <a:extLst>
              <a:ext uri="{FF2B5EF4-FFF2-40B4-BE49-F238E27FC236}">
                <a16:creationId xmlns:a16="http://schemas.microsoft.com/office/drawing/2014/main" id="{64FAC9AB-D908-4C4A-8483-677EC03BD9E9}"/>
              </a:ext>
            </a:extLst>
          </p:cNvPr>
          <p:cNvGrpSpPr/>
          <p:nvPr/>
        </p:nvGrpSpPr>
        <p:grpSpPr>
          <a:xfrm>
            <a:off x="3889568" y="751978"/>
            <a:ext cx="536768" cy="960042"/>
            <a:chOff x="236117" y="524063"/>
            <a:chExt cx="759843" cy="1232122"/>
          </a:xfrm>
        </p:grpSpPr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DDF77554-85AD-8244-AA57-C9CFAFAE587C}"/>
                </a:ext>
              </a:extLst>
            </p:cNvPr>
            <p:cNvCxnSpPr>
              <a:cxnSpLocks/>
            </p:cNvCxnSpPr>
            <p:nvPr/>
          </p:nvCxnSpPr>
          <p:spPr>
            <a:xfrm>
              <a:off x="236117" y="759755"/>
              <a:ext cx="759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>
              <a:extLst>
                <a:ext uri="{FF2B5EF4-FFF2-40B4-BE49-F238E27FC236}">
                  <a16:creationId xmlns:a16="http://schemas.microsoft.com/office/drawing/2014/main" id="{ED3BCDF4-FDEC-864D-A9F2-6BF0B50BAFC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95959" y="754951"/>
              <a:ext cx="1" cy="88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ED886280-7B04-094C-960E-B1AB6728FC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6117" y="764890"/>
              <a:ext cx="0" cy="99129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74139212-8A78-9F40-8FDA-32832CB464F1}"/>
                </a:ext>
              </a:extLst>
            </p:cNvPr>
            <p:cNvSpPr txBox="1"/>
            <p:nvPr/>
          </p:nvSpPr>
          <p:spPr>
            <a:xfrm>
              <a:off x="423845" y="524063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**</a:t>
              </a:r>
            </a:p>
          </p:txBody>
        </p:sp>
      </p:grpSp>
      <p:grpSp>
        <p:nvGrpSpPr>
          <p:cNvPr id="137" name="Group 136">
            <a:extLst>
              <a:ext uri="{FF2B5EF4-FFF2-40B4-BE49-F238E27FC236}">
                <a16:creationId xmlns:a16="http://schemas.microsoft.com/office/drawing/2014/main" id="{1721A42B-49A6-164B-A345-4DF20E95004A}"/>
              </a:ext>
            </a:extLst>
          </p:cNvPr>
          <p:cNvGrpSpPr/>
          <p:nvPr/>
        </p:nvGrpSpPr>
        <p:grpSpPr>
          <a:xfrm>
            <a:off x="4065828" y="612734"/>
            <a:ext cx="489403" cy="919254"/>
            <a:chOff x="236117" y="517218"/>
            <a:chExt cx="759843" cy="1089245"/>
          </a:xfrm>
        </p:grpSpPr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B5CE52A6-62CA-2949-9C5E-690B99B89B3E}"/>
                </a:ext>
              </a:extLst>
            </p:cNvPr>
            <p:cNvCxnSpPr>
              <a:cxnSpLocks/>
            </p:cNvCxnSpPr>
            <p:nvPr/>
          </p:nvCxnSpPr>
          <p:spPr>
            <a:xfrm>
              <a:off x="236117" y="759755"/>
              <a:ext cx="759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6CD69D1E-9431-AE4D-B07B-15A138FE0A8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95959" y="754951"/>
              <a:ext cx="1" cy="88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DC075D64-F934-CA42-8F3B-78EEFD0A5E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6117" y="764890"/>
              <a:ext cx="0" cy="8415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7E4D5CB5-A808-0644-96B1-9FFB4E0442DF}"/>
                </a:ext>
              </a:extLst>
            </p:cNvPr>
            <p:cNvSpPr txBox="1"/>
            <p:nvPr/>
          </p:nvSpPr>
          <p:spPr>
            <a:xfrm>
              <a:off x="347579" y="517218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**</a:t>
              </a:r>
            </a:p>
          </p:txBody>
        </p:sp>
      </p:grpSp>
      <p:graphicFrame>
        <p:nvGraphicFramePr>
          <p:cNvPr id="142" name="Chart 141">
            <a:extLst>
              <a:ext uri="{FF2B5EF4-FFF2-40B4-BE49-F238E27FC236}">
                <a16:creationId xmlns:a16="http://schemas.microsoft.com/office/drawing/2014/main" id="{384CD5D1-40E8-8D45-AB54-6CE19BFE5A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4196059"/>
              </p:ext>
            </p:extLst>
          </p:nvPr>
        </p:nvGraphicFramePr>
        <p:xfrm>
          <a:off x="3461937" y="2564090"/>
          <a:ext cx="1338663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143" name="Group 142">
            <a:extLst>
              <a:ext uri="{FF2B5EF4-FFF2-40B4-BE49-F238E27FC236}">
                <a16:creationId xmlns:a16="http://schemas.microsoft.com/office/drawing/2014/main" id="{5FE364FD-39D2-1043-A0DD-5566EDF85D81}"/>
              </a:ext>
            </a:extLst>
          </p:cNvPr>
          <p:cNvGrpSpPr/>
          <p:nvPr/>
        </p:nvGrpSpPr>
        <p:grpSpPr>
          <a:xfrm>
            <a:off x="3880351" y="2827417"/>
            <a:ext cx="850482" cy="864712"/>
            <a:chOff x="5082" y="1348907"/>
            <a:chExt cx="1167227" cy="1715101"/>
          </a:xfrm>
        </p:grpSpPr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id="{547818CF-3457-AF46-BB94-8E0B7EEB7849}"/>
                </a:ext>
              </a:extLst>
            </p:cNvPr>
            <p:cNvCxnSpPr>
              <a:cxnSpLocks/>
            </p:cNvCxnSpPr>
            <p:nvPr/>
          </p:nvCxnSpPr>
          <p:spPr>
            <a:xfrm>
              <a:off x="39542" y="2769134"/>
              <a:ext cx="2107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0843708E-A3F2-2E41-B72B-F0CBA99F19A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542" y="2769134"/>
              <a:ext cx="0" cy="88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>
              <a:extLst>
                <a:ext uri="{FF2B5EF4-FFF2-40B4-BE49-F238E27FC236}">
                  <a16:creationId xmlns:a16="http://schemas.microsoft.com/office/drawing/2014/main" id="{83172EB7-3B4C-8546-A1DE-7B42DF73A9B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0290" y="2769134"/>
              <a:ext cx="0" cy="294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A2AC214D-A697-B849-A5C5-2C0AD346C3F5}"/>
                </a:ext>
              </a:extLst>
            </p:cNvPr>
            <p:cNvSpPr txBox="1"/>
            <p:nvPr/>
          </p:nvSpPr>
          <p:spPr>
            <a:xfrm>
              <a:off x="5082" y="2421688"/>
              <a:ext cx="341441" cy="48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*</a:t>
              </a:r>
            </a:p>
          </p:txBody>
        </p: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1F4BA0EB-D8A7-6E40-900D-8CACAEF0B1AA}"/>
                </a:ext>
              </a:extLst>
            </p:cNvPr>
            <p:cNvCxnSpPr>
              <a:cxnSpLocks/>
            </p:cNvCxnSpPr>
            <p:nvPr/>
          </p:nvCxnSpPr>
          <p:spPr>
            <a:xfrm>
              <a:off x="40929" y="1776348"/>
              <a:ext cx="759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322B4066-7340-7447-BABE-7612B185C7B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00771" y="1771544"/>
              <a:ext cx="1" cy="88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4CC2FD11-B80A-4641-92BB-9B2D9520998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542" y="1771545"/>
              <a:ext cx="1387" cy="9210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9FB84F14-A2E9-5141-B7ED-0D58EAE6D7F9}"/>
                </a:ext>
              </a:extLst>
            </p:cNvPr>
            <p:cNvSpPr txBox="1"/>
            <p:nvPr/>
          </p:nvSpPr>
          <p:spPr>
            <a:xfrm>
              <a:off x="241246" y="1433689"/>
              <a:ext cx="341441" cy="48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*</a:t>
              </a:r>
            </a:p>
          </p:txBody>
        </p: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id="{0C4481D3-84DA-EF4A-BA1F-68D55721CB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23519" y="1671361"/>
              <a:ext cx="0" cy="127510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F74AD361-3EF0-1D41-94F1-4A22A0A5B6DF}"/>
                </a:ext>
              </a:extLst>
            </p:cNvPr>
            <p:cNvSpPr txBox="1"/>
            <p:nvPr/>
          </p:nvSpPr>
          <p:spPr>
            <a:xfrm>
              <a:off x="742868" y="1348907"/>
              <a:ext cx="429441" cy="48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**</a:t>
              </a:r>
            </a:p>
          </p:txBody>
        </p: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E1BF99C4-E63E-6F47-9CFF-5554A8C136F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6111" y="1674560"/>
              <a:ext cx="1" cy="790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A7FBB93D-EAAA-5C4D-A431-77EB4B6550D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00771" y="1677513"/>
              <a:ext cx="2227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76" name="Chart 175">
            <a:extLst>
              <a:ext uri="{FF2B5EF4-FFF2-40B4-BE49-F238E27FC236}">
                <a16:creationId xmlns:a16="http://schemas.microsoft.com/office/drawing/2014/main" id="{1595E867-54F4-6348-8BDE-195AD7566B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8681833"/>
              </p:ext>
            </p:extLst>
          </p:nvPr>
        </p:nvGraphicFramePr>
        <p:xfrm>
          <a:off x="1595697" y="2556546"/>
          <a:ext cx="137160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177" name="Group 176">
            <a:extLst>
              <a:ext uri="{FF2B5EF4-FFF2-40B4-BE49-F238E27FC236}">
                <a16:creationId xmlns:a16="http://schemas.microsoft.com/office/drawing/2014/main" id="{6CAD422E-4FC1-F945-8147-23E0B3A22EA2}"/>
              </a:ext>
            </a:extLst>
          </p:cNvPr>
          <p:cNvGrpSpPr/>
          <p:nvPr/>
        </p:nvGrpSpPr>
        <p:grpSpPr>
          <a:xfrm>
            <a:off x="2023472" y="2865242"/>
            <a:ext cx="759552" cy="861894"/>
            <a:chOff x="5809350" y="2535022"/>
            <a:chExt cx="1025255" cy="1760590"/>
          </a:xfrm>
        </p:grpSpPr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87E20ADE-8339-EC4F-A289-4299F3E561FF}"/>
                </a:ext>
              </a:extLst>
            </p:cNvPr>
            <p:cNvCxnSpPr>
              <a:cxnSpLocks/>
            </p:cNvCxnSpPr>
            <p:nvPr/>
          </p:nvCxnSpPr>
          <p:spPr>
            <a:xfrm>
              <a:off x="5809350" y="3034308"/>
              <a:ext cx="75984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Straight Connector 178">
              <a:extLst>
                <a:ext uri="{FF2B5EF4-FFF2-40B4-BE49-F238E27FC236}">
                  <a16:creationId xmlns:a16="http://schemas.microsoft.com/office/drawing/2014/main" id="{C4DC0165-BA0A-4249-8B53-0607C7E59CD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569192" y="3029504"/>
              <a:ext cx="1" cy="887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Straight Connector 179">
              <a:extLst>
                <a:ext uri="{FF2B5EF4-FFF2-40B4-BE49-F238E27FC236}">
                  <a16:creationId xmlns:a16="http://schemas.microsoft.com/office/drawing/2014/main" id="{4CA016CA-BAC2-3C43-B7F5-6A26B2F593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09350" y="3029504"/>
              <a:ext cx="0" cy="12661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60901213-6165-7B4F-8388-4EFACE708127}"/>
                </a:ext>
              </a:extLst>
            </p:cNvPr>
            <p:cNvSpPr txBox="1"/>
            <p:nvPr/>
          </p:nvSpPr>
          <p:spPr>
            <a:xfrm>
              <a:off x="6044783" y="2603344"/>
              <a:ext cx="33855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FED96CAD-C14F-8547-94D7-AACD364A774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91940" y="2929321"/>
              <a:ext cx="0" cy="127510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1C4C3396-6B95-9E4C-A770-78A4A2EFD60E}"/>
                </a:ext>
              </a:extLst>
            </p:cNvPr>
            <p:cNvSpPr txBox="1"/>
            <p:nvPr/>
          </p:nvSpPr>
          <p:spPr>
            <a:xfrm>
              <a:off x="6496051" y="2535022"/>
              <a:ext cx="338554" cy="276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**</a:t>
              </a:r>
            </a:p>
          </p:txBody>
        </p:sp>
        <p:cxnSp>
          <p:nvCxnSpPr>
            <p:cNvPr id="196" name="Straight Connector 195">
              <a:extLst>
                <a:ext uri="{FF2B5EF4-FFF2-40B4-BE49-F238E27FC236}">
                  <a16:creationId xmlns:a16="http://schemas.microsoft.com/office/drawing/2014/main" id="{1E4A8D5B-B9C8-3B45-B01E-F687F832F2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74532" y="2932520"/>
              <a:ext cx="1" cy="790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Straight Connector 196">
              <a:extLst>
                <a:ext uri="{FF2B5EF4-FFF2-40B4-BE49-F238E27FC236}">
                  <a16:creationId xmlns:a16="http://schemas.microsoft.com/office/drawing/2014/main" id="{9684CA32-2E4D-B94E-9B61-69F47B32F0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69192" y="2935473"/>
              <a:ext cx="2227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7" name="TextBox 116">
            <a:extLst>
              <a:ext uri="{FF2B5EF4-FFF2-40B4-BE49-F238E27FC236}">
                <a16:creationId xmlns:a16="http://schemas.microsoft.com/office/drawing/2014/main" id="{E7CF7209-AEA8-B448-A89F-1EE4698F2652}"/>
              </a:ext>
            </a:extLst>
          </p:cNvPr>
          <p:cNvSpPr txBox="1"/>
          <p:nvPr/>
        </p:nvSpPr>
        <p:spPr>
          <a:xfrm rot="16200000">
            <a:off x="-149429" y="3007076"/>
            <a:ext cx="2497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ative gene expression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F627E71-58CB-587F-72D7-C49BC3249CCE}"/>
              </a:ext>
            </a:extLst>
          </p:cNvPr>
          <p:cNvSpPr/>
          <p:nvPr/>
        </p:nvSpPr>
        <p:spPr>
          <a:xfrm>
            <a:off x="6810594" y="6446541"/>
            <a:ext cx="16001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Batang" panose="02030600000101010101" pitchFamily="18" charset="-127"/>
              </a:rPr>
              <a:t>Supplementary Fig. 6</a:t>
            </a:r>
            <a:endParaRPr lang="en-US" sz="1200" dirty="0"/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B9091848-E7FA-DBD3-5CEC-CF4B81369D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9524039"/>
              </p:ext>
            </p:extLst>
          </p:nvPr>
        </p:nvGraphicFramePr>
        <p:xfrm>
          <a:off x="3336519" y="4644794"/>
          <a:ext cx="1464081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D93D2D9-FE5E-17C6-F07E-884A8B77AC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5358103"/>
              </p:ext>
            </p:extLst>
          </p:nvPr>
        </p:nvGraphicFramePr>
        <p:xfrm>
          <a:off x="1597705" y="4644794"/>
          <a:ext cx="1369592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8F94056-FA04-FF06-717D-ACC82811A35E}"/>
              </a:ext>
            </a:extLst>
          </p:cNvPr>
          <p:cNvSpPr txBox="1"/>
          <p:nvPr/>
        </p:nvSpPr>
        <p:spPr>
          <a:xfrm>
            <a:off x="2585613" y="5128067"/>
            <a:ext cx="356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C403FE9-091C-99E5-D947-3974D162AD4B}"/>
              </a:ext>
            </a:extLst>
          </p:cNvPr>
          <p:cNvSpPr txBox="1"/>
          <p:nvPr/>
        </p:nvSpPr>
        <p:spPr>
          <a:xfrm>
            <a:off x="2076549" y="5102444"/>
            <a:ext cx="230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F6DECEB8-DB8C-24F9-939F-58D31087F3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1047128"/>
              </p:ext>
            </p:extLst>
          </p:nvPr>
        </p:nvGraphicFramePr>
        <p:xfrm>
          <a:off x="5028327" y="4659904"/>
          <a:ext cx="1487675" cy="18143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C78E551F-4F3A-953B-5881-CC029EA11F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9364665"/>
              </p:ext>
            </p:extLst>
          </p:nvPr>
        </p:nvGraphicFramePr>
        <p:xfrm>
          <a:off x="5052495" y="2616328"/>
          <a:ext cx="1487675" cy="1799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8C4E3C5-47EF-5E45-960E-A687BDB9240E}"/>
              </a:ext>
            </a:extLst>
          </p:cNvPr>
          <p:cNvCxnSpPr>
            <a:cxnSpLocks/>
          </p:cNvCxnSpPr>
          <p:nvPr/>
        </p:nvCxnSpPr>
        <p:spPr>
          <a:xfrm>
            <a:off x="5618306" y="3791702"/>
            <a:ext cx="1535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C8ACEB0-BEC7-99C0-6B9B-D60935D5BB34}"/>
              </a:ext>
            </a:extLst>
          </p:cNvPr>
          <p:cNvCxnSpPr>
            <a:cxnSpLocks/>
          </p:cNvCxnSpPr>
          <p:nvPr/>
        </p:nvCxnSpPr>
        <p:spPr>
          <a:xfrm flipV="1">
            <a:off x="5618306" y="3791702"/>
            <a:ext cx="0" cy="447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F19F039-210E-BF63-612A-63F04F4A07E8}"/>
              </a:ext>
            </a:extLst>
          </p:cNvPr>
          <p:cNvCxnSpPr>
            <a:cxnSpLocks/>
          </p:cNvCxnSpPr>
          <p:nvPr/>
        </p:nvCxnSpPr>
        <p:spPr>
          <a:xfrm flipV="1">
            <a:off x="5771864" y="3791702"/>
            <a:ext cx="0" cy="1486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1C96D5C3-D8F3-9125-1976-5D04C903448F}"/>
              </a:ext>
            </a:extLst>
          </p:cNvPr>
          <p:cNvSpPr txBox="1"/>
          <p:nvPr/>
        </p:nvSpPr>
        <p:spPr>
          <a:xfrm>
            <a:off x="5593197" y="3616528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D63AEF1-5B9A-696B-FE61-FCF37C1C8582}"/>
              </a:ext>
            </a:extLst>
          </p:cNvPr>
          <p:cNvCxnSpPr>
            <a:cxnSpLocks/>
          </p:cNvCxnSpPr>
          <p:nvPr/>
        </p:nvCxnSpPr>
        <p:spPr>
          <a:xfrm>
            <a:off x="5619316" y="3052262"/>
            <a:ext cx="5536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CF5CE025-1872-AF83-A4D9-CD11C195FC03}"/>
              </a:ext>
            </a:extLst>
          </p:cNvPr>
          <p:cNvCxnSpPr>
            <a:cxnSpLocks/>
          </p:cNvCxnSpPr>
          <p:nvPr/>
        </p:nvCxnSpPr>
        <p:spPr>
          <a:xfrm flipH="1" flipV="1">
            <a:off x="6172964" y="3049840"/>
            <a:ext cx="1" cy="447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67006E8-A85F-1EE9-E98A-3523D50C193C}"/>
              </a:ext>
            </a:extLst>
          </p:cNvPr>
          <p:cNvCxnSpPr>
            <a:cxnSpLocks/>
          </p:cNvCxnSpPr>
          <p:nvPr/>
        </p:nvCxnSpPr>
        <p:spPr>
          <a:xfrm flipV="1">
            <a:off x="5620924" y="3058270"/>
            <a:ext cx="0" cy="6042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A1D6450B-B944-09D2-3D47-04C6D17B7E17}"/>
              </a:ext>
            </a:extLst>
          </p:cNvPr>
          <p:cNvSpPr txBox="1"/>
          <p:nvPr/>
        </p:nvSpPr>
        <p:spPr>
          <a:xfrm>
            <a:off x="5715846" y="287950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**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B02141C-4C49-4C7F-4C47-E1A48BCA203C}"/>
              </a:ext>
            </a:extLst>
          </p:cNvPr>
          <p:cNvCxnSpPr>
            <a:cxnSpLocks/>
          </p:cNvCxnSpPr>
          <p:nvPr/>
        </p:nvCxnSpPr>
        <p:spPr>
          <a:xfrm flipV="1">
            <a:off x="6335265" y="2999330"/>
            <a:ext cx="0" cy="6428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9D8B508C-0482-781E-B9A6-A9E08CF27380}"/>
              </a:ext>
            </a:extLst>
          </p:cNvPr>
          <p:cNvSpPr txBox="1"/>
          <p:nvPr/>
        </p:nvSpPr>
        <p:spPr>
          <a:xfrm>
            <a:off x="6097821" y="2836757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**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B8B4DA1-42AA-8E64-0EAD-7DAF6E4BE39D}"/>
              </a:ext>
            </a:extLst>
          </p:cNvPr>
          <p:cNvCxnSpPr>
            <a:cxnSpLocks/>
          </p:cNvCxnSpPr>
          <p:nvPr/>
        </p:nvCxnSpPr>
        <p:spPr>
          <a:xfrm flipV="1">
            <a:off x="6176854" y="3000943"/>
            <a:ext cx="1" cy="39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7BD63AF-E144-37E0-40A1-BC15F9AE61D2}"/>
              </a:ext>
            </a:extLst>
          </p:cNvPr>
          <p:cNvCxnSpPr>
            <a:cxnSpLocks/>
          </p:cNvCxnSpPr>
          <p:nvPr/>
        </p:nvCxnSpPr>
        <p:spPr>
          <a:xfrm flipH="1">
            <a:off x="6172964" y="3002432"/>
            <a:ext cx="1623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D7F99CED-1D67-F34D-61A4-97635399FB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8291061"/>
              </p:ext>
            </p:extLst>
          </p:nvPr>
        </p:nvGraphicFramePr>
        <p:xfrm>
          <a:off x="6745705" y="2616328"/>
          <a:ext cx="1351596" cy="17999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4B3A334-4F1D-E291-5381-9863EA2A88E8}"/>
              </a:ext>
            </a:extLst>
          </p:cNvPr>
          <p:cNvCxnSpPr>
            <a:cxnSpLocks/>
          </p:cNvCxnSpPr>
          <p:nvPr/>
        </p:nvCxnSpPr>
        <p:spPr>
          <a:xfrm>
            <a:off x="7235219" y="3097685"/>
            <a:ext cx="5367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8C27AD3F-0545-06F1-906F-D91EFC6287A5}"/>
              </a:ext>
            </a:extLst>
          </p:cNvPr>
          <p:cNvCxnSpPr>
            <a:cxnSpLocks/>
          </p:cNvCxnSpPr>
          <p:nvPr/>
        </p:nvCxnSpPr>
        <p:spPr>
          <a:xfrm flipH="1" flipV="1">
            <a:off x="7771986" y="3093181"/>
            <a:ext cx="1" cy="432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B879B5D4-25F4-E1DF-F7D9-15CA80AACEBC}"/>
              </a:ext>
            </a:extLst>
          </p:cNvPr>
          <p:cNvCxnSpPr>
            <a:cxnSpLocks/>
          </p:cNvCxnSpPr>
          <p:nvPr/>
        </p:nvCxnSpPr>
        <p:spPr>
          <a:xfrm flipV="1">
            <a:off x="7235219" y="3093221"/>
            <a:ext cx="0" cy="7738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187E485-F6C4-C123-4A49-BDAF4B20A6BE}"/>
              </a:ext>
            </a:extLst>
          </p:cNvPr>
          <p:cNvSpPr txBox="1"/>
          <p:nvPr/>
        </p:nvSpPr>
        <p:spPr>
          <a:xfrm>
            <a:off x="7305580" y="2888146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**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70EFCEDE-24FD-BC73-749B-FFD66ECCC8B7}"/>
              </a:ext>
            </a:extLst>
          </p:cNvPr>
          <p:cNvCxnSpPr>
            <a:cxnSpLocks/>
          </p:cNvCxnSpPr>
          <p:nvPr/>
        </p:nvCxnSpPr>
        <p:spPr>
          <a:xfrm flipV="1">
            <a:off x="7918725" y="2998501"/>
            <a:ext cx="0" cy="7652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1B86E75E-8EE6-B67F-3C53-D3BD9226EF47}"/>
              </a:ext>
            </a:extLst>
          </p:cNvPr>
          <p:cNvSpPr txBox="1"/>
          <p:nvPr/>
        </p:nvSpPr>
        <p:spPr>
          <a:xfrm>
            <a:off x="7664089" y="282595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***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781477DB-6676-B0C9-3AC7-B172A3B1B185}"/>
              </a:ext>
            </a:extLst>
          </p:cNvPr>
          <p:cNvCxnSpPr>
            <a:cxnSpLocks/>
          </p:cNvCxnSpPr>
          <p:nvPr/>
        </p:nvCxnSpPr>
        <p:spPr>
          <a:xfrm flipV="1">
            <a:off x="7770033" y="2998501"/>
            <a:ext cx="1" cy="790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B65F5154-17DF-2AE1-0DF6-72AE418496BB}"/>
              </a:ext>
            </a:extLst>
          </p:cNvPr>
          <p:cNvCxnSpPr>
            <a:cxnSpLocks/>
          </p:cNvCxnSpPr>
          <p:nvPr/>
        </p:nvCxnSpPr>
        <p:spPr>
          <a:xfrm flipH="1">
            <a:off x="7770034" y="2998501"/>
            <a:ext cx="1457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966432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4F23020-2CDF-632E-FB7A-96A8D528A9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2132329"/>
              </p:ext>
            </p:extLst>
          </p:nvPr>
        </p:nvGraphicFramePr>
        <p:xfrm>
          <a:off x="2477445" y="2640881"/>
          <a:ext cx="137160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951B6A0-230D-6C51-681B-011F0DA84B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3723683"/>
              </p:ext>
            </p:extLst>
          </p:nvPr>
        </p:nvGraphicFramePr>
        <p:xfrm>
          <a:off x="4216441" y="2640881"/>
          <a:ext cx="137160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B6AD726B-CFB5-A4BD-F968-7A9F0287FF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740935"/>
              </p:ext>
            </p:extLst>
          </p:nvPr>
        </p:nvGraphicFramePr>
        <p:xfrm>
          <a:off x="5836107" y="2640881"/>
          <a:ext cx="137160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7" name="Group 6">
            <a:extLst>
              <a:ext uri="{FF2B5EF4-FFF2-40B4-BE49-F238E27FC236}">
                <a16:creationId xmlns:a16="http://schemas.microsoft.com/office/drawing/2014/main" id="{A96F6894-D372-9D17-1D44-28A31461F00F}"/>
              </a:ext>
            </a:extLst>
          </p:cNvPr>
          <p:cNvGrpSpPr/>
          <p:nvPr/>
        </p:nvGrpSpPr>
        <p:grpSpPr>
          <a:xfrm>
            <a:off x="7455773" y="2442593"/>
            <a:ext cx="932156" cy="594358"/>
            <a:chOff x="5925276" y="876647"/>
            <a:chExt cx="932156" cy="584390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144E6DF-0E51-0B01-A746-61919546A556}"/>
                </a:ext>
              </a:extLst>
            </p:cNvPr>
            <p:cNvSpPr/>
            <p:nvPr/>
          </p:nvSpPr>
          <p:spPr>
            <a:xfrm>
              <a:off x="5925276" y="963660"/>
              <a:ext cx="137160" cy="13716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77"/>
              <a:endParaRPr lang="en-US" sz="1200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A672219C-8CE8-7F30-05D8-586CC0530E90}"/>
                </a:ext>
              </a:extLst>
            </p:cNvPr>
            <p:cNvSpPr/>
            <p:nvPr/>
          </p:nvSpPr>
          <p:spPr>
            <a:xfrm>
              <a:off x="5925276" y="1271049"/>
              <a:ext cx="137160" cy="137160"/>
            </a:xfrm>
            <a:prstGeom prst="rect">
              <a:avLst/>
            </a:prstGeom>
            <a:solidFill>
              <a:srgbClr val="EE7D3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914377"/>
              <a:endParaRPr lang="en-US" sz="1200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407E58D-2D54-78A9-76CD-4E77CB320CC5}"/>
                </a:ext>
              </a:extLst>
            </p:cNvPr>
            <p:cNvSpPr txBox="1"/>
            <p:nvPr/>
          </p:nvSpPr>
          <p:spPr>
            <a:xfrm>
              <a:off x="6129462" y="876647"/>
              <a:ext cx="5504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377"/>
              <a:r>
                <a:rPr lang="en-US" sz="1200" dirty="0">
                  <a:solidFill>
                    <a:prstClr val="black"/>
                  </a:solidFill>
                  <a:latin typeface="Calibri" panose="020F0502020204030204"/>
                </a:rPr>
                <a:t>WT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3625F5A-CCFE-605C-6497-9DF31E11F789}"/>
                </a:ext>
              </a:extLst>
            </p:cNvPr>
            <p:cNvSpPr txBox="1"/>
            <p:nvPr/>
          </p:nvSpPr>
          <p:spPr>
            <a:xfrm>
              <a:off x="6129463" y="1184038"/>
              <a:ext cx="7279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377"/>
              <a:r>
                <a:rPr lang="en-US" sz="1200" dirty="0">
                  <a:solidFill>
                    <a:prstClr val="black"/>
                  </a:solidFill>
                  <a:latin typeface="Calibri" panose="020F0502020204030204"/>
                </a:rPr>
                <a:t>CKO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C8EE22F8-5276-EB17-41C1-0E5BA57C1325}"/>
              </a:ext>
            </a:extLst>
          </p:cNvPr>
          <p:cNvSpPr txBox="1"/>
          <p:nvPr/>
        </p:nvSpPr>
        <p:spPr>
          <a:xfrm>
            <a:off x="2904052" y="3106480"/>
            <a:ext cx="3129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**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A828652-8B14-E63F-6022-7126351DC826}"/>
              </a:ext>
            </a:extLst>
          </p:cNvPr>
          <p:cNvSpPr txBox="1"/>
          <p:nvPr/>
        </p:nvSpPr>
        <p:spPr>
          <a:xfrm>
            <a:off x="3463121" y="3137302"/>
            <a:ext cx="474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**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7AEF9E-3C1B-79F5-863F-D8399DB26C71}"/>
              </a:ext>
            </a:extLst>
          </p:cNvPr>
          <p:cNvSpPr txBox="1"/>
          <p:nvPr/>
        </p:nvSpPr>
        <p:spPr>
          <a:xfrm rot="16200000">
            <a:off x="633472" y="3096295"/>
            <a:ext cx="2497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lative gene expression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1B02A71-2201-6A63-7DCA-4573783000D9}"/>
              </a:ext>
            </a:extLst>
          </p:cNvPr>
          <p:cNvSpPr/>
          <p:nvPr/>
        </p:nvSpPr>
        <p:spPr>
          <a:xfrm>
            <a:off x="6875908" y="6353235"/>
            <a:ext cx="16385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Batang" panose="02030600000101010101" pitchFamily="18" charset="-127"/>
              </a:rPr>
              <a:t>Supplementary Fig. 7</a:t>
            </a:r>
            <a:r>
              <a:rPr lang="en-US" sz="1200" dirty="0">
                <a:latin typeface="Times New Roman" panose="02020603050405020304" pitchFamily="18" charset="0"/>
                <a:ea typeface="Batang" panose="02030600000101010101" pitchFamily="18" charset="-127"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76366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23</TotalTime>
  <Words>216</Words>
  <Application>Microsoft Macintosh PowerPoint</Application>
  <PresentationFormat>Letter Paper (8.5x11 in)</PresentationFormat>
  <Paragraphs>155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ng, Hong Soon (NIH/NIEHS) [E]</dc:creator>
  <cp:lastModifiedBy>Kang, Hong Soon (NIH/NIEHS) [E]</cp:lastModifiedBy>
  <cp:revision>80</cp:revision>
  <cp:lastPrinted>2023-04-13T15:18:01Z</cp:lastPrinted>
  <dcterms:created xsi:type="dcterms:W3CDTF">2021-10-26T18:46:22Z</dcterms:created>
  <dcterms:modified xsi:type="dcterms:W3CDTF">2023-10-11T21:52:26Z</dcterms:modified>
</cp:coreProperties>
</file>